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60" r:id="rId5"/>
    <p:sldId id="261" r:id="rId6"/>
    <p:sldId id="263" r:id="rId7"/>
    <p:sldId id="264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49" d="100"/>
          <a:sy n="49" d="100"/>
        </p:scale>
        <p:origin x="51" y="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BE4F24-ABAD-4BA2-8ABC-C956220C56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3D4A3F-60A9-4DC7-ADFB-744A66A87B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114FDB-FA50-4919-879C-E2CA5FD43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63C4E5-4633-47CC-952F-247516235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979B6F-69BC-423D-A127-DB5DB3015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6797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54B306-87FF-4BA8-AFA3-25B27F8D98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FA0556-6FEE-4228-9C8D-8B0E47396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A30B70-F38B-476C-8EB7-37EE4B528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507DDD-4980-47F8-8002-4C50CB1CB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9E35FE-FBC6-4E7E-964B-CDD7E52A8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794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D4C58CE-8673-4647-B2D5-7595E3FB68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6D30897-AB97-4366-A1CA-079A4328DE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7F13D8-75C2-4A82-88A6-4688D62FB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DAE658-8F5E-4A4B-816A-1B1A94BFA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6D2948-B950-4CEA-B527-4ACD33FDC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3729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2B1056-B222-4436-A2F3-0B6443E10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511EA6-7B69-42A6-BAF7-3ADBF45F6D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3F8D69-B9C1-495C-AB7C-AAC3720B6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4612DD-0F2F-4800-AD71-DB285DD8F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CB5F40-30BA-4FBE-A4B2-6A9148D89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756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790F80-D095-4750-8387-5AAFF10F5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ECF961-FE9B-41AA-B9ED-5AA035F6A6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FB54F7-53EB-464E-93A1-80F1FAA59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E9CA03-DBCB-4960-8ECE-907FE9CB6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FB9296-3579-4830-B5A0-D3A281D15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659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B773C9-907C-439A-8FB7-563A74585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EF42427-1BB8-484A-9CF2-8BFF2A429B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55F01E-0C8A-43D4-B2E2-668956D49B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CC4688-5133-415B-AA9D-44A34A5F7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A300CB-A28B-491D-B7BD-1BD76A1E6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4C6646-682C-4ACA-817F-CE4ECE3C5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6144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3120E3-F330-4BFF-9AE4-63AEF2DA5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72F1FB-5007-4C89-8438-6163AED295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5031D9D-E7A5-4BC6-98A7-8ECA7CD785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280ABCC-E2C0-44F0-A8E0-1BA8D5E449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5C00004-8D69-456C-8A6F-FE67DAC4B2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8A0F7AB-45C2-44AE-99A9-972CA454E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473A16F-9910-4AB2-B8B6-A6ED3BCF4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FE22AEA-B702-4336-B085-7FB51FDF0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313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E01F38-449B-4A19-B5FC-FC4047369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FC4C294-36E5-4FA1-ADAF-1987C83B9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E184CBD-43E6-4CB8-B7A9-0AB33F27F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E2987A3-1850-4A01-B5BA-073E57D33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215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1EA2028-7480-46DA-8732-EC05A4725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8ED2345-14E6-4973-96E3-F1E24C371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89CCBFD-E0EE-46D8-9F7A-3AFB4B23C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058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BDF92D-3733-4D15-A9C9-0231CBEBA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61E4D55-3EDD-4D99-97F4-88124DED1E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EDD7ACE-18D0-4950-B440-DE95EE2621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1ECA78-DE7A-4F20-AE3B-662A0BCDA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9A2E21-3C0E-4A74-AB65-99126B16B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3C3CE5-1D2C-41CA-B5D5-1A86C88A6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085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F3834D-42DF-4952-8913-90C79BEAC3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5B0CEA2-4FF2-4F4A-8937-4E5FE10B8A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C60F3B-AA30-47AB-BE66-C06D1D517D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F3F5C8-D02A-4398-91AC-3F40DC37E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D914AFB-9179-416A-9E26-92752570C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5CF52A-B66A-439F-B2D7-C5AEB531A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622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B84C76C-6E00-40B1-9373-946D8A1E79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4F10B2-F397-48D0-89F2-013B2D7AB2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8DE4B0-3E57-4A29-BA92-62808CD6FF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8C817-5876-4F58-8804-945401E8DED2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C500B5-E7BD-493E-AA88-5C56B481AF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8DB3B-EFCE-4EF9-8FAB-AF40B3AF6C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C993D-FC6C-422B-B0E9-88FE153C25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941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"/><Relationship Id="rId3" Type="http://schemas.openxmlformats.org/officeDocument/2006/relationships/image" Target="../media/image7.tif"/><Relationship Id="rId7" Type="http://schemas.openxmlformats.org/officeDocument/2006/relationships/image" Target="../media/image11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"/><Relationship Id="rId5" Type="http://schemas.openxmlformats.org/officeDocument/2006/relationships/image" Target="../media/image9.png"/><Relationship Id="rId10" Type="http://schemas.openxmlformats.org/officeDocument/2006/relationships/image" Target="../media/image14.tif"/><Relationship Id="rId4" Type="http://schemas.openxmlformats.org/officeDocument/2006/relationships/image" Target="../media/image8.png"/><Relationship Id="rId9" Type="http://schemas.openxmlformats.org/officeDocument/2006/relationships/image" Target="../media/image1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"/><Relationship Id="rId5" Type="http://schemas.openxmlformats.org/officeDocument/2006/relationships/image" Target="../media/image18.tif"/><Relationship Id="rId4" Type="http://schemas.openxmlformats.org/officeDocument/2006/relationships/image" Target="../media/image17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7" Type="http://schemas.openxmlformats.org/officeDocument/2006/relationships/image" Target="../media/image28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"/><Relationship Id="rId5" Type="http://schemas.openxmlformats.org/officeDocument/2006/relationships/image" Target="../media/image26.tif"/><Relationship Id="rId4" Type="http://schemas.openxmlformats.org/officeDocument/2006/relationships/image" Target="../media/image25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32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tif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78D66079-045D-49D0-B702-99A9BB6C83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5972" y="762440"/>
            <a:ext cx="7017306" cy="274439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86F1ED0-6CA0-469F-8677-84D691869E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378" r="11808" b="20120"/>
          <a:stretch/>
        </p:blipFill>
        <p:spPr>
          <a:xfrm>
            <a:off x="3125972" y="3707733"/>
            <a:ext cx="6962016" cy="241272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3F93BD23-0F6A-446B-8AFD-B046E9DE8217}"/>
              </a:ext>
            </a:extLst>
          </p:cNvPr>
          <p:cNvSpPr txBox="1"/>
          <p:nvPr/>
        </p:nvSpPr>
        <p:spPr>
          <a:xfrm>
            <a:off x="1836995" y="737545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1e</a:t>
            </a: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F8F5C008-EEF1-4CC3-BD0E-2C3A3D2E7B6E}"/>
              </a:ext>
            </a:extLst>
          </p:cNvPr>
          <p:cNvGrpSpPr/>
          <p:nvPr/>
        </p:nvGrpSpPr>
        <p:grpSpPr>
          <a:xfrm>
            <a:off x="4638676" y="1263524"/>
            <a:ext cx="1080726" cy="712918"/>
            <a:chOff x="808073" y="1322402"/>
            <a:chExt cx="1080726" cy="712918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6316787-660B-4455-B053-000FB808166C}"/>
                </a:ext>
              </a:extLst>
            </p:cNvPr>
            <p:cNvSpPr txBox="1"/>
            <p:nvPr/>
          </p:nvSpPr>
          <p:spPr>
            <a:xfrm>
              <a:off x="893135" y="1322402"/>
              <a:ext cx="8374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ARP1</a:t>
              </a: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9125C67-9AFB-4521-95CB-3975F2BD1B70}"/>
                </a:ext>
              </a:extLst>
            </p:cNvPr>
            <p:cNvSpPr txBox="1"/>
            <p:nvPr/>
          </p:nvSpPr>
          <p:spPr>
            <a:xfrm>
              <a:off x="808073" y="1696766"/>
              <a:ext cx="599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4783633A-5AA4-469F-B9AB-8AEF117CB2F9}"/>
                </a:ext>
              </a:extLst>
            </p:cNvPr>
            <p:cNvSpPr txBox="1"/>
            <p:nvPr/>
          </p:nvSpPr>
          <p:spPr>
            <a:xfrm>
              <a:off x="1407577" y="1696766"/>
              <a:ext cx="4812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968F7805-7405-4362-B39A-0F772F4378F0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矩形 24">
            <a:extLst>
              <a:ext uri="{FF2B5EF4-FFF2-40B4-BE49-F238E27FC236}">
                <a16:creationId xmlns:a16="http://schemas.microsoft.com/office/drawing/2014/main" id="{E9EC7970-5757-4FAD-B003-3570804E5F1C}"/>
              </a:ext>
            </a:extLst>
          </p:cNvPr>
          <p:cNvSpPr/>
          <p:nvPr/>
        </p:nvSpPr>
        <p:spPr>
          <a:xfrm>
            <a:off x="4396005" y="2000373"/>
            <a:ext cx="5316279" cy="44937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0ABAAA11-59DF-4D1F-A9EC-F0E648AC5A91}"/>
              </a:ext>
            </a:extLst>
          </p:cNvPr>
          <p:cNvGrpSpPr/>
          <p:nvPr/>
        </p:nvGrpSpPr>
        <p:grpSpPr>
          <a:xfrm>
            <a:off x="5887384" y="1245619"/>
            <a:ext cx="1080726" cy="712918"/>
            <a:chOff x="808073" y="1322402"/>
            <a:chExt cx="1080726" cy="712918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E47FB8A-0AF8-4EE8-BD9A-3229F2326EEC}"/>
                </a:ext>
              </a:extLst>
            </p:cNvPr>
            <p:cNvSpPr txBox="1"/>
            <p:nvPr/>
          </p:nvSpPr>
          <p:spPr>
            <a:xfrm>
              <a:off x="893135" y="1322402"/>
              <a:ext cx="788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H929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FFBD97E-3DBD-483B-8717-336016E61571}"/>
                </a:ext>
              </a:extLst>
            </p:cNvPr>
            <p:cNvSpPr txBox="1"/>
            <p:nvPr/>
          </p:nvSpPr>
          <p:spPr>
            <a:xfrm>
              <a:off x="808073" y="1696766"/>
              <a:ext cx="599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AE907F39-3710-4572-8F9D-02BFA4C902DA}"/>
                </a:ext>
              </a:extLst>
            </p:cNvPr>
            <p:cNvSpPr txBox="1"/>
            <p:nvPr/>
          </p:nvSpPr>
          <p:spPr>
            <a:xfrm>
              <a:off x="1407577" y="1696766"/>
              <a:ext cx="4812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FC5CD3C8-EE05-4DD4-BA5D-786690581F14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AD4C810F-5D46-47A9-BFC2-4008190CFE77}"/>
              </a:ext>
            </a:extLst>
          </p:cNvPr>
          <p:cNvGrpSpPr/>
          <p:nvPr/>
        </p:nvGrpSpPr>
        <p:grpSpPr>
          <a:xfrm>
            <a:off x="7163873" y="1260015"/>
            <a:ext cx="1079122" cy="712918"/>
            <a:chOff x="808073" y="1322402"/>
            <a:chExt cx="1079122" cy="712918"/>
          </a:xfrm>
        </p:grpSpPr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E22AECF1-06B5-4147-A8BC-63C540C13208}"/>
                </a:ext>
              </a:extLst>
            </p:cNvPr>
            <p:cNvSpPr txBox="1"/>
            <p:nvPr/>
          </p:nvSpPr>
          <p:spPr>
            <a:xfrm>
              <a:off x="893135" y="1322402"/>
              <a:ext cx="8374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ARP1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1069D4A-B18D-4FDD-9D45-E9A0C8D8F240}"/>
                </a:ext>
              </a:extLst>
            </p:cNvPr>
            <p:cNvSpPr txBox="1"/>
            <p:nvPr/>
          </p:nvSpPr>
          <p:spPr>
            <a:xfrm>
              <a:off x="808073" y="1696766"/>
              <a:ext cx="599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1F84A73A-ADE7-4C38-8F39-398F170C08DD}"/>
                </a:ext>
              </a:extLst>
            </p:cNvPr>
            <p:cNvSpPr txBox="1"/>
            <p:nvPr/>
          </p:nvSpPr>
          <p:spPr>
            <a:xfrm>
              <a:off x="1407577" y="1696766"/>
              <a:ext cx="4796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363A7DC1-BB85-40D1-BC34-BB15263E7D0C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D7A7EB2F-E2DD-40E3-8191-0455538E94C3}"/>
              </a:ext>
            </a:extLst>
          </p:cNvPr>
          <p:cNvGrpSpPr/>
          <p:nvPr/>
        </p:nvGrpSpPr>
        <p:grpSpPr>
          <a:xfrm>
            <a:off x="8440362" y="1263524"/>
            <a:ext cx="1079122" cy="712918"/>
            <a:chOff x="808073" y="1322402"/>
            <a:chExt cx="1079122" cy="712918"/>
          </a:xfrm>
        </p:grpSpPr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DC729D9-B2B6-45F8-BD46-5710CE0E58F8}"/>
                </a:ext>
              </a:extLst>
            </p:cNvPr>
            <p:cNvSpPr txBox="1"/>
            <p:nvPr/>
          </p:nvSpPr>
          <p:spPr>
            <a:xfrm>
              <a:off x="893135" y="1322402"/>
              <a:ext cx="788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H929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CA475F15-965C-40EB-914C-44356D827718}"/>
                </a:ext>
              </a:extLst>
            </p:cNvPr>
            <p:cNvSpPr txBox="1"/>
            <p:nvPr/>
          </p:nvSpPr>
          <p:spPr>
            <a:xfrm>
              <a:off x="808073" y="1696766"/>
              <a:ext cx="599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E0905137-3790-423A-BC1B-F5311E0A496F}"/>
                </a:ext>
              </a:extLst>
            </p:cNvPr>
            <p:cNvSpPr txBox="1"/>
            <p:nvPr/>
          </p:nvSpPr>
          <p:spPr>
            <a:xfrm>
              <a:off x="1407577" y="1696766"/>
              <a:ext cx="4796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3FE4612D-645B-41E9-BE69-92571FCB6610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49F30E77-B941-4407-AE9C-254573779195}"/>
              </a:ext>
            </a:extLst>
          </p:cNvPr>
          <p:cNvGrpSpPr/>
          <p:nvPr/>
        </p:nvGrpSpPr>
        <p:grpSpPr>
          <a:xfrm>
            <a:off x="4309970" y="4008505"/>
            <a:ext cx="5316279" cy="1204132"/>
            <a:chOff x="4151456" y="1868516"/>
            <a:chExt cx="5316279" cy="1204132"/>
          </a:xfrm>
        </p:grpSpPr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0B07E7F1-51FC-4305-A59A-9FEDA22EFFC6}"/>
                </a:ext>
              </a:extLst>
            </p:cNvPr>
            <p:cNvGrpSpPr/>
            <p:nvPr/>
          </p:nvGrpSpPr>
          <p:grpSpPr>
            <a:xfrm>
              <a:off x="4394127" y="1886421"/>
              <a:ext cx="1080726" cy="712918"/>
              <a:chOff x="808073" y="1322402"/>
              <a:chExt cx="1080726" cy="712918"/>
            </a:xfrm>
          </p:grpSpPr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0011B2D3-92F8-4DA1-B404-C238B3A628F0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8374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ARP1</a:t>
                </a: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1B65E7DF-E917-4795-AA78-3614F597FFA0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69E6C5B1-7BA0-41B4-95DE-408FC67DC607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直接连接符 63">
                <a:extLst>
                  <a:ext uri="{FF2B5EF4-FFF2-40B4-BE49-F238E27FC236}">
                    <a16:creationId xmlns:a16="http://schemas.microsoft.com/office/drawing/2014/main" id="{8BEB9F57-CD3D-417E-AEAB-BF2F8E0DAFA5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E8EF3AD8-55D2-405F-B70A-24C0B4F8E244}"/>
                </a:ext>
              </a:extLst>
            </p:cNvPr>
            <p:cNvSpPr/>
            <p:nvPr/>
          </p:nvSpPr>
          <p:spPr>
            <a:xfrm>
              <a:off x="4151456" y="2623270"/>
              <a:ext cx="5316279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55EF78F7-CE15-41EB-85A5-73869D4D70C5}"/>
                </a:ext>
              </a:extLst>
            </p:cNvPr>
            <p:cNvGrpSpPr/>
            <p:nvPr/>
          </p:nvGrpSpPr>
          <p:grpSpPr>
            <a:xfrm>
              <a:off x="5642835" y="1868516"/>
              <a:ext cx="1080726" cy="712918"/>
              <a:chOff x="808073" y="1322402"/>
              <a:chExt cx="1080726" cy="712918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AB4A29DF-410D-4025-8456-434BA3828DA1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H929</a:t>
                </a: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90DA3C95-A822-44EF-8CEC-7E54253DDB97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F0A13B00-580C-4AD0-9DE1-F495596B686C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0" name="直接连接符 59">
                <a:extLst>
                  <a:ext uri="{FF2B5EF4-FFF2-40B4-BE49-F238E27FC236}">
                    <a16:creationId xmlns:a16="http://schemas.microsoft.com/office/drawing/2014/main" id="{AB39E9F9-2AA5-4F3E-9A39-D3EC2F0F04D1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9238A121-B8C1-4795-8348-0380D9DE842F}"/>
                </a:ext>
              </a:extLst>
            </p:cNvPr>
            <p:cNvGrpSpPr/>
            <p:nvPr/>
          </p:nvGrpSpPr>
          <p:grpSpPr>
            <a:xfrm>
              <a:off x="6919324" y="1882912"/>
              <a:ext cx="1079122" cy="712918"/>
              <a:chOff x="808073" y="1322402"/>
              <a:chExt cx="1079122" cy="712918"/>
            </a:xfrm>
          </p:grpSpPr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5E22BBDC-446F-46C1-9EF9-1DEF35DABFF0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8374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ARP1</a:t>
                </a: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A6DD3072-C5CF-4FC2-82E9-8181672153CE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4D195261-D5E2-45F5-9732-9BAE3CF6217D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7961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E3D35DAD-18E7-48EC-B9DB-E75E2FD605BB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63E2267A-0E06-41E4-B46F-7113F2818AC4}"/>
                </a:ext>
              </a:extLst>
            </p:cNvPr>
            <p:cNvGrpSpPr/>
            <p:nvPr/>
          </p:nvGrpSpPr>
          <p:grpSpPr>
            <a:xfrm>
              <a:off x="8195813" y="1886421"/>
              <a:ext cx="1079122" cy="712918"/>
              <a:chOff x="808073" y="1322402"/>
              <a:chExt cx="1079122" cy="712918"/>
            </a:xfrm>
          </p:grpSpPr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6E271D88-B193-40BB-9685-46B63BC30E4A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H929</a:t>
                </a: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44E415EC-3B3E-4DBD-A9B6-688FF473DC39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9B9FBB74-1BEC-4DBE-81D3-E89EE5502D1F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7961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D67264FE-1CB5-4A22-A5A6-56CEEE951174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5" name="文本框 64">
            <a:extLst>
              <a:ext uri="{FF2B5EF4-FFF2-40B4-BE49-F238E27FC236}">
                <a16:creationId xmlns:a16="http://schemas.microsoft.com/office/drawing/2014/main" id="{B47E9805-2300-4CEE-BF4F-FCD430F91C2C}"/>
              </a:ext>
            </a:extLst>
          </p:cNvPr>
          <p:cNvSpPr txBox="1"/>
          <p:nvPr/>
        </p:nvSpPr>
        <p:spPr>
          <a:xfrm>
            <a:off x="3381511" y="2040396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XN2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3A73A7E-D2D1-43E1-9308-D98D9AC67928}"/>
              </a:ext>
            </a:extLst>
          </p:cNvPr>
          <p:cNvSpPr txBox="1"/>
          <p:nvPr/>
        </p:nvSpPr>
        <p:spPr>
          <a:xfrm>
            <a:off x="3321024" y="4763259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0548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999"/>
    </mc:Choice>
    <mc:Fallback xmlns="">
      <p:transition spd="slow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42A38C18-5819-40A6-B679-B0A8273A64EE}"/>
              </a:ext>
            </a:extLst>
          </p:cNvPr>
          <p:cNvSpPr txBox="1"/>
          <p:nvPr/>
        </p:nvSpPr>
        <p:spPr>
          <a:xfrm>
            <a:off x="180432" y="17588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2b </a:t>
            </a:r>
          </a:p>
        </p:txBody>
      </p: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AC2DAFB7-5320-4F93-8D65-159B1B0B9093}"/>
              </a:ext>
            </a:extLst>
          </p:cNvPr>
          <p:cNvGrpSpPr/>
          <p:nvPr/>
        </p:nvGrpSpPr>
        <p:grpSpPr>
          <a:xfrm>
            <a:off x="1604225" y="388137"/>
            <a:ext cx="3492399" cy="3090029"/>
            <a:chOff x="1651312" y="712310"/>
            <a:chExt cx="3492399" cy="3090029"/>
          </a:xfrm>
        </p:grpSpPr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0BCD40C9-8744-435E-88CF-6BAE045C20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65825" y="712310"/>
              <a:ext cx="3377886" cy="3090029"/>
            </a:xfrm>
            <a:prstGeom prst="rect">
              <a:avLst/>
            </a:prstGeom>
          </p:spPr>
        </p:pic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C5D1C3D4-9B29-432C-AC91-70088FAF9072}"/>
                </a:ext>
              </a:extLst>
            </p:cNvPr>
            <p:cNvSpPr/>
            <p:nvPr/>
          </p:nvSpPr>
          <p:spPr>
            <a:xfrm>
              <a:off x="2579771" y="2071701"/>
              <a:ext cx="1883047" cy="37124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CBD21E8-F4D4-42B8-A881-E4BED3D144FD}"/>
                </a:ext>
              </a:extLst>
            </p:cNvPr>
            <p:cNvSpPr txBox="1"/>
            <p:nvPr/>
          </p:nvSpPr>
          <p:spPr>
            <a:xfrm>
              <a:off x="1651312" y="2067499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FXN2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D28DEE48-4D22-4858-83BF-2513224DD8E0}"/>
                </a:ext>
              </a:extLst>
            </p:cNvPr>
            <p:cNvGrpSpPr/>
            <p:nvPr/>
          </p:nvGrpSpPr>
          <p:grpSpPr>
            <a:xfrm>
              <a:off x="2512819" y="1188845"/>
              <a:ext cx="1028776" cy="639955"/>
              <a:chOff x="808073" y="1322402"/>
              <a:chExt cx="1307052" cy="791556"/>
            </a:xfrm>
          </p:grpSpPr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B35F22D9-734F-436D-BE01-8065D54B667F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8374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ARP1</a:t>
                </a: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3A87436D-F779-488A-85B5-24A2649ADEAF}"/>
                  </a:ext>
                </a:extLst>
              </p:cNvPr>
              <p:cNvSpPr txBox="1"/>
              <p:nvPr/>
            </p:nvSpPr>
            <p:spPr>
              <a:xfrm>
                <a:off x="808073" y="1696768"/>
                <a:ext cx="707549" cy="4171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EC2256EC-57DC-4CB3-A819-2BA1DD907FA3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707548" cy="4171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接连接符 42">
                <a:extLst>
                  <a:ext uri="{FF2B5EF4-FFF2-40B4-BE49-F238E27FC236}">
                    <a16:creationId xmlns:a16="http://schemas.microsoft.com/office/drawing/2014/main" id="{8C440E34-C356-4EB5-8EF7-0FA56A203A7A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EE836B3D-A82F-423C-9FFD-E0BA8F19BAC2}"/>
                </a:ext>
              </a:extLst>
            </p:cNvPr>
            <p:cNvGrpSpPr/>
            <p:nvPr/>
          </p:nvGrpSpPr>
          <p:grpSpPr>
            <a:xfrm>
              <a:off x="3548493" y="1188844"/>
              <a:ext cx="1028776" cy="639955"/>
              <a:chOff x="808073" y="1322402"/>
              <a:chExt cx="1307052" cy="791556"/>
            </a:xfrm>
          </p:grpSpPr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4385FD56-C608-4EA2-AACB-F132823083B3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1002417" cy="4187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H929</a:t>
                </a: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77CB3BAF-D94F-43BF-9F37-EC819DC60000}"/>
                  </a:ext>
                </a:extLst>
              </p:cNvPr>
              <p:cNvSpPr txBox="1"/>
              <p:nvPr/>
            </p:nvSpPr>
            <p:spPr>
              <a:xfrm>
                <a:off x="808073" y="1696768"/>
                <a:ext cx="707549" cy="4171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8D4A9166-E5CB-4498-9965-E9476E54DEE3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707548" cy="4171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to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00E41D42-B7AA-4923-BB56-07E2BB688317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50" name="图片 49">
            <a:extLst>
              <a:ext uri="{FF2B5EF4-FFF2-40B4-BE49-F238E27FC236}">
                <a16:creationId xmlns:a16="http://schemas.microsoft.com/office/drawing/2014/main" id="{39CDB164-0865-4539-963C-CA27060095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82" t="5960" r="19566" b="19162"/>
          <a:stretch/>
        </p:blipFill>
        <p:spPr>
          <a:xfrm>
            <a:off x="7284569" y="496927"/>
            <a:ext cx="3177285" cy="3090029"/>
          </a:xfrm>
          <a:prstGeom prst="rect">
            <a:avLst/>
          </a:prstGeom>
        </p:spPr>
      </p:pic>
      <p:sp>
        <p:nvSpPr>
          <p:cNvPr id="52" name="矩形 51">
            <a:extLst>
              <a:ext uri="{FF2B5EF4-FFF2-40B4-BE49-F238E27FC236}">
                <a16:creationId xmlns:a16="http://schemas.microsoft.com/office/drawing/2014/main" id="{017DEB93-D4E1-43F0-B5F4-0BEC78EACAC0}"/>
              </a:ext>
            </a:extLst>
          </p:cNvPr>
          <p:cNvSpPr/>
          <p:nvPr/>
        </p:nvSpPr>
        <p:spPr>
          <a:xfrm>
            <a:off x="8202820" y="1679983"/>
            <a:ext cx="2047952" cy="37124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7C8AC284-0147-4E81-8D80-7E586B5582DE}"/>
              </a:ext>
            </a:extLst>
          </p:cNvPr>
          <p:cNvGrpSpPr/>
          <p:nvPr/>
        </p:nvGrpSpPr>
        <p:grpSpPr>
          <a:xfrm>
            <a:off x="8122891" y="1001563"/>
            <a:ext cx="1028776" cy="639955"/>
            <a:chOff x="808073" y="1322402"/>
            <a:chExt cx="1307052" cy="791556"/>
          </a:xfrm>
        </p:grpSpPr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0B463F3B-804B-46F0-AFA2-B15C5E656FB7}"/>
                </a:ext>
              </a:extLst>
            </p:cNvPr>
            <p:cNvSpPr txBox="1"/>
            <p:nvPr/>
          </p:nvSpPr>
          <p:spPr>
            <a:xfrm>
              <a:off x="893135" y="1322402"/>
              <a:ext cx="8374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ARP1</a:t>
              </a: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20F3A2B-8435-4E26-9B0A-3EA712E96350}"/>
                </a:ext>
              </a:extLst>
            </p:cNvPr>
            <p:cNvSpPr txBox="1"/>
            <p:nvPr/>
          </p:nvSpPr>
          <p:spPr>
            <a:xfrm>
              <a:off x="808073" y="1696768"/>
              <a:ext cx="707549" cy="417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AC375D98-724A-4103-A604-2C3AE0E862FF}"/>
                </a:ext>
              </a:extLst>
            </p:cNvPr>
            <p:cNvSpPr txBox="1"/>
            <p:nvPr/>
          </p:nvSpPr>
          <p:spPr>
            <a:xfrm>
              <a:off x="1407577" y="1696766"/>
              <a:ext cx="707548" cy="417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F53AC4DF-A680-4A8D-ACBA-233818E135F6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AB6EF90F-D826-4F34-B1F8-721DF6E17914}"/>
              </a:ext>
            </a:extLst>
          </p:cNvPr>
          <p:cNvGrpSpPr/>
          <p:nvPr/>
        </p:nvGrpSpPr>
        <p:grpSpPr>
          <a:xfrm>
            <a:off x="9248163" y="984250"/>
            <a:ext cx="1028776" cy="639955"/>
            <a:chOff x="808073" y="1322402"/>
            <a:chExt cx="1307052" cy="791556"/>
          </a:xfrm>
        </p:grpSpPr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2E438D4F-15C3-4E49-85BD-CFE4103C751E}"/>
                </a:ext>
              </a:extLst>
            </p:cNvPr>
            <p:cNvSpPr txBox="1"/>
            <p:nvPr/>
          </p:nvSpPr>
          <p:spPr>
            <a:xfrm>
              <a:off x="893135" y="1322402"/>
              <a:ext cx="1002417" cy="418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H929</a:t>
              </a: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D0EEB9E5-C9D7-4310-A7C0-293E9062CB97}"/>
                </a:ext>
              </a:extLst>
            </p:cNvPr>
            <p:cNvSpPr txBox="1"/>
            <p:nvPr/>
          </p:nvSpPr>
          <p:spPr>
            <a:xfrm>
              <a:off x="808073" y="1696768"/>
              <a:ext cx="707549" cy="417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F128D739-75C8-4A17-A8BF-71E0C5602BE3}"/>
                </a:ext>
              </a:extLst>
            </p:cNvPr>
            <p:cNvSpPr txBox="1"/>
            <p:nvPr/>
          </p:nvSpPr>
          <p:spPr>
            <a:xfrm>
              <a:off x="1407577" y="1696766"/>
              <a:ext cx="707548" cy="417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1A45B782-0C44-461F-94DC-30069182F898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文本框 69">
            <a:extLst>
              <a:ext uri="{FF2B5EF4-FFF2-40B4-BE49-F238E27FC236}">
                <a16:creationId xmlns:a16="http://schemas.microsoft.com/office/drawing/2014/main" id="{1ACE00FB-4624-4C18-B7FB-6749FFB872B3}"/>
              </a:ext>
            </a:extLst>
          </p:cNvPr>
          <p:cNvSpPr txBox="1"/>
          <p:nvPr/>
        </p:nvSpPr>
        <p:spPr>
          <a:xfrm>
            <a:off x="6892851" y="1649509"/>
            <a:ext cx="1220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376117" eaLnBrk="1" hangingPunct="1">
              <a:defRPr/>
            </a:pPr>
            <a:r>
              <a:rPr lang="el-GR" altLang="zh-CN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id="{C652A4D8-62DD-40AE-8ED1-58AE504D90A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77" t="15479" r="24491" b="35243"/>
          <a:stretch/>
        </p:blipFill>
        <p:spPr>
          <a:xfrm>
            <a:off x="4807773" y="4444163"/>
            <a:ext cx="2822379" cy="2304235"/>
          </a:xfrm>
          <a:prstGeom prst="rect">
            <a:avLst/>
          </a:prstGeom>
        </p:spPr>
      </p:pic>
      <p:grpSp>
        <p:nvGrpSpPr>
          <p:cNvPr id="73" name="组合 72">
            <a:extLst>
              <a:ext uri="{FF2B5EF4-FFF2-40B4-BE49-F238E27FC236}">
                <a16:creationId xmlns:a16="http://schemas.microsoft.com/office/drawing/2014/main" id="{D29556F4-0C40-422F-A407-8ED071049D7F}"/>
              </a:ext>
            </a:extLst>
          </p:cNvPr>
          <p:cNvGrpSpPr/>
          <p:nvPr/>
        </p:nvGrpSpPr>
        <p:grpSpPr>
          <a:xfrm>
            <a:off x="5067224" y="4754774"/>
            <a:ext cx="1028776" cy="639955"/>
            <a:chOff x="808073" y="1322402"/>
            <a:chExt cx="1307052" cy="791556"/>
          </a:xfrm>
        </p:grpSpPr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F319882-F725-4494-9A2A-5F025D4893ED}"/>
                </a:ext>
              </a:extLst>
            </p:cNvPr>
            <p:cNvSpPr txBox="1"/>
            <p:nvPr/>
          </p:nvSpPr>
          <p:spPr>
            <a:xfrm>
              <a:off x="893135" y="1322402"/>
              <a:ext cx="8374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ARP1</a:t>
              </a: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F808B362-8E17-44DE-A9F1-065CB177D1AE}"/>
                </a:ext>
              </a:extLst>
            </p:cNvPr>
            <p:cNvSpPr txBox="1"/>
            <p:nvPr/>
          </p:nvSpPr>
          <p:spPr>
            <a:xfrm>
              <a:off x="808073" y="1696768"/>
              <a:ext cx="707549" cy="417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BC8ED9CF-33E3-43AA-AFD9-FE82B7E14D0C}"/>
                </a:ext>
              </a:extLst>
            </p:cNvPr>
            <p:cNvSpPr txBox="1"/>
            <p:nvPr/>
          </p:nvSpPr>
          <p:spPr>
            <a:xfrm>
              <a:off x="1407577" y="1696766"/>
              <a:ext cx="707548" cy="417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98F22AD6-CFC9-4B9B-B668-18FF00CAF6C9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1D5598A2-B0C2-44C0-A385-C7471B65D9A1}"/>
              </a:ext>
            </a:extLst>
          </p:cNvPr>
          <p:cNvGrpSpPr/>
          <p:nvPr/>
        </p:nvGrpSpPr>
        <p:grpSpPr>
          <a:xfrm>
            <a:off x="6356810" y="4763927"/>
            <a:ext cx="1028776" cy="639955"/>
            <a:chOff x="808073" y="1322402"/>
            <a:chExt cx="1307052" cy="791556"/>
          </a:xfrm>
        </p:grpSpPr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336FE09D-8171-4D4E-90FF-0BA7CF112A7C}"/>
                </a:ext>
              </a:extLst>
            </p:cNvPr>
            <p:cNvSpPr txBox="1"/>
            <p:nvPr/>
          </p:nvSpPr>
          <p:spPr>
            <a:xfrm>
              <a:off x="893135" y="1322402"/>
              <a:ext cx="1002417" cy="418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H929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8C3B55CB-5378-45B2-BDC3-003856E92A6E}"/>
                </a:ext>
              </a:extLst>
            </p:cNvPr>
            <p:cNvSpPr txBox="1"/>
            <p:nvPr/>
          </p:nvSpPr>
          <p:spPr>
            <a:xfrm>
              <a:off x="808073" y="1696768"/>
              <a:ext cx="707549" cy="417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C39B778A-3736-4CA6-96A5-FA79EB5F9095}"/>
                </a:ext>
              </a:extLst>
            </p:cNvPr>
            <p:cNvSpPr txBox="1"/>
            <p:nvPr/>
          </p:nvSpPr>
          <p:spPr>
            <a:xfrm>
              <a:off x="1407577" y="1696766"/>
              <a:ext cx="707548" cy="417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zh-CN" alt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D5F64575-5F46-40A8-95A1-2AF5328A5E91}"/>
                </a:ext>
              </a:extLst>
            </p:cNvPr>
            <p:cNvCxnSpPr/>
            <p:nvPr/>
          </p:nvCxnSpPr>
          <p:spPr>
            <a:xfrm>
              <a:off x="808073" y="1660956"/>
              <a:ext cx="1074314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4" name="矩形 83">
            <a:extLst>
              <a:ext uri="{FF2B5EF4-FFF2-40B4-BE49-F238E27FC236}">
                <a16:creationId xmlns:a16="http://schemas.microsoft.com/office/drawing/2014/main" id="{2940F3DF-A0FC-4FC3-9C60-62291816458A}"/>
              </a:ext>
            </a:extLst>
          </p:cNvPr>
          <p:cNvSpPr/>
          <p:nvPr/>
        </p:nvSpPr>
        <p:spPr>
          <a:xfrm>
            <a:off x="5067224" y="5422245"/>
            <a:ext cx="2326406" cy="37124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5" name="文本框 37">
            <a:extLst>
              <a:ext uri="{FF2B5EF4-FFF2-40B4-BE49-F238E27FC236}">
                <a16:creationId xmlns:a16="http://schemas.microsoft.com/office/drawing/2014/main" id="{A9CAB03B-DAA9-41C3-8179-D446EAFBAC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7606" y="5449905"/>
            <a:ext cx="1008242" cy="246221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>
            <a:spAutoFit/>
          </a:bodyPr>
          <a:lstStyle>
            <a:lvl1pPr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608013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608013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608013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608013" eaLnBrk="0" fontAlgn="base" hangingPunct="0">
              <a:spcBef>
                <a:spcPct val="0"/>
              </a:spcBef>
              <a:spcAft>
                <a:spcPct val="0"/>
              </a:spcAft>
              <a:defRPr sz="2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r" defTabSz="376117" eaLnBrk="1" hangingPunct="1">
              <a:defRPr/>
            </a:pPr>
            <a:r>
              <a:rPr lang="en-US" altLang="zh-CN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 IV</a:t>
            </a:r>
            <a:endParaRPr lang="zh-CN" altLang="en-US" sz="1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40147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999"/>
    </mc:Choice>
    <mc:Fallback xmlns="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104F3F85-6329-45D4-86B2-F8EBFB9912DC}"/>
              </a:ext>
            </a:extLst>
          </p:cNvPr>
          <p:cNvSpPr txBox="1"/>
          <p:nvPr/>
        </p:nvSpPr>
        <p:spPr>
          <a:xfrm>
            <a:off x="180432" y="175889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a</a:t>
            </a:r>
            <a:endParaRPr lang="en-US" altLang="zh-CN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4E2C5751-AC04-4B98-A8C9-9392C7A43428}"/>
              </a:ext>
            </a:extLst>
          </p:cNvPr>
          <p:cNvGrpSpPr/>
          <p:nvPr/>
        </p:nvGrpSpPr>
        <p:grpSpPr>
          <a:xfrm>
            <a:off x="1106496" y="523160"/>
            <a:ext cx="2655696" cy="2382349"/>
            <a:chOff x="5800288" y="3319614"/>
            <a:chExt cx="2655696" cy="2382349"/>
          </a:xfrm>
        </p:grpSpPr>
        <p:pic>
          <p:nvPicPr>
            <p:cNvPr id="61" name="图片 60">
              <a:extLst>
                <a:ext uri="{FF2B5EF4-FFF2-40B4-BE49-F238E27FC236}">
                  <a16:creationId xmlns:a16="http://schemas.microsoft.com/office/drawing/2014/main" id="{370F7A9F-7CF5-46A4-95A8-03ADD763FD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0288" y="3429000"/>
              <a:ext cx="2655696" cy="2272963"/>
            </a:xfrm>
            <a:prstGeom prst="rect">
              <a:avLst/>
            </a:prstGeom>
          </p:spPr>
        </p:pic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E3B73D49-6EDE-494A-8286-914540D7031D}"/>
                </a:ext>
              </a:extLst>
            </p:cNvPr>
            <p:cNvSpPr/>
            <p:nvPr/>
          </p:nvSpPr>
          <p:spPr>
            <a:xfrm>
              <a:off x="5800288" y="4072135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269016AC-2B5B-400E-B9C4-2355A946C34A}"/>
                </a:ext>
              </a:extLst>
            </p:cNvPr>
            <p:cNvGrpSpPr/>
            <p:nvPr/>
          </p:nvGrpSpPr>
          <p:grpSpPr>
            <a:xfrm>
              <a:off x="5965297" y="3348823"/>
              <a:ext cx="1079122" cy="712918"/>
              <a:chOff x="808073" y="1322402"/>
              <a:chExt cx="1079122" cy="712918"/>
            </a:xfrm>
          </p:grpSpPr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900A1C12-F0D3-4D8E-893E-78C16C25F535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8374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ARP1</a:t>
                </a: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29B44E25-E11B-4207-BF1D-9C0616B07785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7DDE4330-1BAD-4DA1-AF03-A3CDEB62BA5F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7961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F1208AE6-0A5C-494A-A487-0483AA5FE3C6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3275D556-5A84-42D5-986B-9956556C5FB0}"/>
                </a:ext>
              </a:extLst>
            </p:cNvPr>
            <p:cNvGrpSpPr/>
            <p:nvPr/>
          </p:nvGrpSpPr>
          <p:grpSpPr>
            <a:xfrm>
              <a:off x="7209427" y="3319614"/>
              <a:ext cx="1079122" cy="712918"/>
              <a:chOff x="808073" y="1322402"/>
              <a:chExt cx="1079122" cy="712918"/>
            </a:xfrm>
          </p:grpSpPr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E1871648-3632-425B-8FAF-C2E18EE8A210}"/>
                  </a:ext>
                </a:extLst>
              </p:cNvPr>
              <p:cNvSpPr txBox="1"/>
              <p:nvPr/>
            </p:nvSpPr>
            <p:spPr>
              <a:xfrm>
                <a:off x="893135" y="1322402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H929</a:t>
                </a: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AABC8016-8B57-4649-9F89-38B09DDAAB59}"/>
                  </a:ext>
                </a:extLst>
              </p:cNvPr>
              <p:cNvSpPr txBox="1"/>
              <p:nvPr/>
            </p:nvSpPr>
            <p:spPr>
              <a:xfrm>
                <a:off x="808073" y="1696766"/>
                <a:ext cx="5995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80B7B5DD-9F3A-4377-95CF-F7E5F3DADD5B}"/>
                  </a:ext>
                </a:extLst>
              </p:cNvPr>
              <p:cNvSpPr txBox="1"/>
              <p:nvPr/>
            </p:nvSpPr>
            <p:spPr>
              <a:xfrm>
                <a:off x="1407577" y="1696766"/>
                <a:ext cx="47961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lang="zh-CN" alt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E4D07540-162B-499C-8787-409DF9B11F42}"/>
                  </a:ext>
                </a:extLst>
              </p:cNvPr>
              <p:cNvCxnSpPr/>
              <p:nvPr/>
            </p:nvCxnSpPr>
            <p:spPr>
              <a:xfrm>
                <a:off x="808073" y="1660956"/>
                <a:ext cx="1074314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4" name="文本框 83">
            <a:extLst>
              <a:ext uri="{FF2B5EF4-FFF2-40B4-BE49-F238E27FC236}">
                <a16:creationId xmlns:a16="http://schemas.microsoft.com/office/drawing/2014/main" id="{327292E6-43A0-4DF6-BF0C-0B2538AD5068}"/>
              </a:ext>
            </a:extLst>
          </p:cNvPr>
          <p:cNvSpPr txBox="1"/>
          <p:nvPr/>
        </p:nvSpPr>
        <p:spPr>
          <a:xfrm>
            <a:off x="255054" y="1297742"/>
            <a:ext cx="783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G5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图片 85">
            <a:extLst>
              <a:ext uri="{FF2B5EF4-FFF2-40B4-BE49-F238E27FC236}">
                <a16:creationId xmlns:a16="http://schemas.microsoft.com/office/drawing/2014/main" id="{F5F270D8-6EB3-41F1-AE09-4823F00179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3244" y="611311"/>
            <a:ext cx="1461585" cy="2272964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90607A96-10A9-413C-A07C-2EC8D7A177C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1913" y="818653"/>
            <a:ext cx="592123" cy="417969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3401F45F-A4C8-4AD8-9E7A-35EB94ECD77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0681" y="817349"/>
            <a:ext cx="589505" cy="419273"/>
          </a:xfrm>
          <a:prstGeom prst="rect">
            <a:avLst/>
          </a:prstGeom>
        </p:spPr>
      </p:pic>
      <p:sp>
        <p:nvSpPr>
          <p:cNvPr id="96" name="矩形 95">
            <a:extLst>
              <a:ext uri="{FF2B5EF4-FFF2-40B4-BE49-F238E27FC236}">
                <a16:creationId xmlns:a16="http://schemas.microsoft.com/office/drawing/2014/main" id="{823FC82A-4324-471A-8BDB-85D7DCF068C1}"/>
              </a:ext>
            </a:extLst>
          </p:cNvPr>
          <p:cNvSpPr/>
          <p:nvPr/>
        </p:nvSpPr>
        <p:spPr>
          <a:xfrm>
            <a:off x="4939687" y="1209840"/>
            <a:ext cx="1461585" cy="27842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FB490917-976D-4E5B-8FFE-48D12C8C1EF6}"/>
              </a:ext>
            </a:extLst>
          </p:cNvPr>
          <p:cNvSpPr txBox="1"/>
          <p:nvPr/>
        </p:nvSpPr>
        <p:spPr>
          <a:xfrm>
            <a:off x="4155861" y="1127821"/>
            <a:ext cx="783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G7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图片 98">
            <a:extLst>
              <a:ext uri="{FF2B5EF4-FFF2-40B4-BE49-F238E27FC236}">
                <a16:creationId xmlns:a16="http://schemas.microsoft.com/office/drawing/2014/main" id="{9A2DEC72-D2D0-4D25-8367-D4609F2FA8B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186"/>
          <a:stretch/>
        </p:blipFill>
        <p:spPr>
          <a:xfrm>
            <a:off x="7996555" y="639735"/>
            <a:ext cx="3157292" cy="2054678"/>
          </a:xfrm>
          <a:prstGeom prst="rect">
            <a:avLst/>
          </a:prstGeom>
        </p:spPr>
      </p:pic>
      <p:grpSp>
        <p:nvGrpSpPr>
          <p:cNvPr id="133" name="组合 132">
            <a:extLst>
              <a:ext uri="{FF2B5EF4-FFF2-40B4-BE49-F238E27FC236}">
                <a16:creationId xmlns:a16="http://schemas.microsoft.com/office/drawing/2014/main" id="{702E6B29-1BE6-4BC1-A1C6-4E8824C560B0}"/>
              </a:ext>
            </a:extLst>
          </p:cNvPr>
          <p:cNvGrpSpPr/>
          <p:nvPr/>
        </p:nvGrpSpPr>
        <p:grpSpPr>
          <a:xfrm>
            <a:off x="7073945" y="679370"/>
            <a:ext cx="4079902" cy="1293112"/>
            <a:chOff x="7073945" y="679370"/>
            <a:chExt cx="4079902" cy="1293112"/>
          </a:xfrm>
        </p:grpSpPr>
        <p:pic>
          <p:nvPicPr>
            <p:cNvPr id="101" name="图片 100">
              <a:extLst>
                <a:ext uri="{FF2B5EF4-FFF2-40B4-BE49-F238E27FC236}">
                  <a16:creationId xmlns:a16="http://schemas.microsoft.com/office/drawing/2014/main" id="{008D0E58-0C7F-4D54-BC18-724407F72D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4583" y="683088"/>
              <a:ext cx="1270611" cy="896902"/>
            </a:xfrm>
            <a:prstGeom prst="rect">
              <a:avLst/>
            </a:prstGeom>
          </p:spPr>
        </p:pic>
        <p:pic>
          <p:nvPicPr>
            <p:cNvPr id="103" name="图片 102">
              <a:extLst>
                <a:ext uri="{FF2B5EF4-FFF2-40B4-BE49-F238E27FC236}">
                  <a16:creationId xmlns:a16="http://schemas.microsoft.com/office/drawing/2014/main" id="{1C4D8B53-B58C-4774-96BD-087215D7588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45627" y="679370"/>
              <a:ext cx="1261058" cy="896902"/>
            </a:xfrm>
            <a:prstGeom prst="rect">
              <a:avLst/>
            </a:prstGeom>
          </p:spPr>
        </p:pic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6CA633A0-D027-4FD6-87B2-5E19E87FBC16}"/>
                </a:ext>
              </a:extLst>
            </p:cNvPr>
            <p:cNvSpPr/>
            <p:nvPr/>
          </p:nvSpPr>
          <p:spPr>
            <a:xfrm>
              <a:off x="8033901" y="1523104"/>
              <a:ext cx="311994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6D04B5A2-9C6D-4D55-9734-87795F61E3C8}"/>
                </a:ext>
              </a:extLst>
            </p:cNvPr>
            <p:cNvSpPr txBox="1"/>
            <p:nvPr/>
          </p:nvSpPr>
          <p:spPr>
            <a:xfrm>
              <a:off x="7073945" y="1523104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9" name="图片 108">
            <a:extLst>
              <a:ext uri="{FF2B5EF4-FFF2-40B4-BE49-F238E27FC236}">
                <a16:creationId xmlns:a16="http://schemas.microsoft.com/office/drawing/2014/main" id="{327B23F1-F388-4377-BCEF-472756471D1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903" y="3666157"/>
            <a:ext cx="1922799" cy="2969386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358EDF3D-1786-4165-B0DF-E75E816487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014" y="4312100"/>
            <a:ext cx="748288" cy="528203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35D818F8-0610-4357-A567-DF3BCAB9D50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8778" y="4330641"/>
            <a:ext cx="690523" cy="491120"/>
          </a:xfrm>
          <a:prstGeom prst="rect">
            <a:avLst/>
          </a:prstGeom>
        </p:spPr>
      </p:pic>
      <p:sp>
        <p:nvSpPr>
          <p:cNvPr id="112" name="矩形 111">
            <a:extLst>
              <a:ext uri="{FF2B5EF4-FFF2-40B4-BE49-F238E27FC236}">
                <a16:creationId xmlns:a16="http://schemas.microsoft.com/office/drawing/2014/main" id="{5906AA29-7B97-44A8-8FD8-A64707ABE243}"/>
              </a:ext>
            </a:extLst>
          </p:cNvPr>
          <p:cNvSpPr/>
          <p:nvPr/>
        </p:nvSpPr>
        <p:spPr>
          <a:xfrm>
            <a:off x="826411" y="4846173"/>
            <a:ext cx="1922799" cy="44937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5" name="图片 114">
            <a:extLst>
              <a:ext uri="{FF2B5EF4-FFF2-40B4-BE49-F238E27FC236}">
                <a16:creationId xmlns:a16="http://schemas.microsoft.com/office/drawing/2014/main" id="{06291511-DF1E-45CC-AE6E-2245569F62E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745" y="3666157"/>
            <a:ext cx="2401688" cy="2969386"/>
          </a:xfrm>
          <a:prstGeom prst="rect">
            <a:avLst/>
          </a:prstGeom>
        </p:spPr>
      </p:pic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C6658605-9C41-413E-AB53-1ED798A52EFC}"/>
              </a:ext>
            </a:extLst>
          </p:cNvPr>
          <p:cNvGrpSpPr/>
          <p:nvPr/>
        </p:nvGrpSpPr>
        <p:grpSpPr>
          <a:xfrm>
            <a:off x="3838403" y="3954155"/>
            <a:ext cx="1922799" cy="1037490"/>
            <a:chOff x="3838403" y="3954155"/>
            <a:chExt cx="1922799" cy="1037490"/>
          </a:xfrm>
        </p:grpSpPr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E8BB97E4-DC9B-4604-B413-FD271747B312}"/>
                </a:ext>
              </a:extLst>
            </p:cNvPr>
            <p:cNvSpPr/>
            <p:nvPr/>
          </p:nvSpPr>
          <p:spPr>
            <a:xfrm>
              <a:off x="3838403" y="4542267"/>
              <a:ext cx="1922799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17" name="图片 116">
              <a:extLst>
                <a:ext uri="{FF2B5EF4-FFF2-40B4-BE49-F238E27FC236}">
                  <a16:creationId xmlns:a16="http://schemas.microsoft.com/office/drawing/2014/main" id="{8177D8EE-56C5-449B-869E-A5C540579B3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5042" y="3954155"/>
              <a:ext cx="748288" cy="528203"/>
            </a:xfrm>
            <a:prstGeom prst="rect">
              <a:avLst/>
            </a:prstGeom>
          </p:spPr>
        </p:pic>
        <p:pic>
          <p:nvPicPr>
            <p:cNvPr id="118" name="图片 117">
              <a:extLst>
                <a:ext uri="{FF2B5EF4-FFF2-40B4-BE49-F238E27FC236}">
                  <a16:creationId xmlns:a16="http://schemas.microsoft.com/office/drawing/2014/main" id="{264741FD-F43B-46B0-9EE5-8794999561F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5101" y="3964147"/>
              <a:ext cx="690523" cy="491120"/>
            </a:xfrm>
            <a:prstGeom prst="rect">
              <a:avLst/>
            </a:prstGeom>
          </p:spPr>
        </p:pic>
      </p:grpSp>
      <p:sp>
        <p:nvSpPr>
          <p:cNvPr id="119" name="文本框 118">
            <a:extLst>
              <a:ext uri="{FF2B5EF4-FFF2-40B4-BE49-F238E27FC236}">
                <a16:creationId xmlns:a16="http://schemas.microsoft.com/office/drawing/2014/main" id="{6F9B6409-41E7-4654-87FC-F5F55374A4A1}"/>
              </a:ext>
            </a:extLst>
          </p:cNvPr>
          <p:cNvSpPr txBox="1"/>
          <p:nvPr/>
        </p:nvSpPr>
        <p:spPr>
          <a:xfrm>
            <a:off x="-52626" y="484786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81939BC1-A8A4-49FF-822C-CEEE56C6A03E}"/>
              </a:ext>
            </a:extLst>
          </p:cNvPr>
          <p:cNvSpPr txBox="1"/>
          <p:nvPr/>
        </p:nvSpPr>
        <p:spPr>
          <a:xfrm>
            <a:off x="2846735" y="4568459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5C90288C-2238-4BBC-B614-BECC1BE530E0}"/>
              </a:ext>
            </a:extLst>
          </p:cNvPr>
          <p:cNvGrpSpPr/>
          <p:nvPr/>
        </p:nvGrpSpPr>
        <p:grpSpPr>
          <a:xfrm>
            <a:off x="7775087" y="2936967"/>
            <a:ext cx="2687438" cy="2054678"/>
            <a:chOff x="6253362" y="3910452"/>
            <a:chExt cx="2687438" cy="2054678"/>
          </a:xfrm>
        </p:grpSpPr>
        <p:pic>
          <p:nvPicPr>
            <p:cNvPr id="121" name="图片 120">
              <a:extLst>
                <a:ext uri="{FF2B5EF4-FFF2-40B4-BE49-F238E27FC236}">
                  <a16:creationId xmlns:a16="http://schemas.microsoft.com/office/drawing/2014/main" id="{4140D53D-2FE1-4BC4-BE69-75B4D0D3A18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8326" y="3910452"/>
              <a:ext cx="2152474" cy="2054678"/>
            </a:xfrm>
            <a:prstGeom prst="rect">
              <a:avLst/>
            </a:prstGeom>
          </p:spPr>
        </p:pic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0F0FE62E-E00C-4668-B0C2-29CEEA564BF4}"/>
                </a:ext>
              </a:extLst>
            </p:cNvPr>
            <p:cNvGrpSpPr/>
            <p:nvPr/>
          </p:nvGrpSpPr>
          <p:grpSpPr>
            <a:xfrm>
              <a:off x="6819968" y="4713944"/>
              <a:ext cx="1922799" cy="1037490"/>
              <a:chOff x="3838403" y="3954155"/>
              <a:chExt cx="1922799" cy="1037490"/>
            </a:xfrm>
          </p:grpSpPr>
          <p:sp>
            <p:nvSpPr>
              <p:cNvPr id="126" name="矩形 125">
                <a:extLst>
                  <a:ext uri="{FF2B5EF4-FFF2-40B4-BE49-F238E27FC236}">
                    <a16:creationId xmlns:a16="http://schemas.microsoft.com/office/drawing/2014/main" id="{E9FC93F1-ED43-4137-A8AB-617388787B54}"/>
                  </a:ext>
                </a:extLst>
              </p:cNvPr>
              <p:cNvSpPr/>
              <p:nvPr/>
            </p:nvSpPr>
            <p:spPr>
              <a:xfrm>
                <a:off x="3838403" y="4542267"/>
                <a:ext cx="1922799" cy="44937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27" name="图片 126">
                <a:extLst>
                  <a:ext uri="{FF2B5EF4-FFF2-40B4-BE49-F238E27FC236}">
                    <a16:creationId xmlns:a16="http://schemas.microsoft.com/office/drawing/2014/main" id="{5939C7EF-18C6-45FA-81D9-6B8077510D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75042" y="3954155"/>
                <a:ext cx="748288" cy="528203"/>
              </a:xfrm>
              <a:prstGeom prst="rect">
                <a:avLst/>
              </a:prstGeom>
            </p:spPr>
          </p:pic>
          <p:pic>
            <p:nvPicPr>
              <p:cNvPr id="128" name="图片 127">
                <a:extLst>
                  <a:ext uri="{FF2B5EF4-FFF2-40B4-BE49-F238E27FC236}">
                    <a16:creationId xmlns:a16="http://schemas.microsoft.com/office/drawing/2014/main" id="{0A6DB847-761E-4EAC-B6F7-B043E2B860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75101" y="3964147"/>
                <a:ext cx="690523" cy="491120"/>
              </a:xfrm>
              <a:prstGeom prst="rect">
                <a:avLst/>
              </a:prstGeom>
            </p:spPr>
          </p:pic>
        </p:grp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99AE925C-B84E-43B9-91EB-98E13372D22F}"/>
                </a:ext>
              </a:extLst>
            </p:cNvPr>
            <p:cNvSpPr txBox="1"/>
            <p:nvPr/>
          </p:nvSpPr>
          <p:spPr>
            <a:xfrm>
              <a:off x="6253362" y="5342079"/>
              <a:ext cx="6206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1" name="图片 130">
            <a:extLst>
              <a:ext uri="{FF2B5EF4-FFF2-40B4-BE49-F238E27FC236}">
                <a16:creationId xmlns:a16="http://schemas.microsoft.com/office/drawing/2014/main" id="{2F657CC8-6602-4133-9CDC-51C79629A39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3901" y="6002790"/>
            <a:ext cx="2980439" cy="549310"/>
          </a:xfrm>
          <a:prstGeom prst="rect">
            <a:avLst/>
          </a:prstGeom>
        </p:spPr>
      </p:pic>
      <p:grpSp>
        <p:nvGrpSpPr>
          <p:cNvPr id="134" name="组合 133">
            <a:extLst>
              <a:ext uri="{FF2B5EF4-FFF2-40B4-BE49-F238E27FC236}">
                <a16:creationId xmlns:a16="http://schemas.microsoft.com/office/drawing/2014/main" id="{6398440D-F197-45B4-B1BD-8819B5D7573C}"/>
              </a:ext>
            </a:extLst>
          </p:cNvPr>
          <p:cNvGrpSpPr/>
          <p:nvPr/>
        </p:nvGrpSpPr>
        <p:grpSpPr>
          <a:xfrm>
            <a:off x="7037200" y="5215513"/>
            <a:ext cx="4079902" cy="1293112"/>
            <a:chOff x="7073945" y="679370"/>
            <a:chExt cx="4079902" cy="1293112"/>
          </a:xfrm>
        </p:grpSpPr>
        <p:pic>
          <p:nvPicPr>
            <p:cNvPr id="135" name="图片 134">
              <a:extLst>
                <a:ext uri="{FF2B5EF4-FFF2-40B4-BE49-F238E27FC236}">
                  <a16:creationId xmlns:a16="http://schemas.microsoft.com/office/drawing/2014/main" id="{3F2DD453-E690-4D2B-B129-D31F7E0E417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14583" y="683088"/>
              <a:ext cx="1270611" cy="896902"/>
            </a:xfrm>
            <a:prstGeom prst="rect">
              <a:avLst/>
            </a:prstGeom>
          </p:spPr>
        </p:pic>
        <p:pic>
          <p:nvPicPr>
            <p:cNvPr id="136" name="图片 135">
              <a:extLst>
                <a:ext uri="{FF2B5EF4-FFF2-40B4-BE49-F238E27FC236}">
                  <a16:creationId xmlns:a16="http://schemas.microsoft.com/office/drawing/2014/main" id="{30CC1306-0F1F-4CDF-BBB8-8440C0F64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45627" y="679370"/>
              <a:ext cx="1261058" cy="896902"/>
            </a:xfrm>
            <a:prstGeom prst="rect">
              <a:avLst/>
            </a:prstGeom>
          </p:spPr>
        </p:pic>
        <p:sp>
          <p:nvSpPr>
            <p:cNvPr id="137" name="矩形 136">
              <a:extLst>
                <a:ext uri="{FF2B5EF4-FFF2-40B4-BE49-F238E27FC236}">
                  <a16:creationId xmlns:a16="http://schemas.microsoft.com/office/drawing/2014/main" id="{6D9D1AB7-B1F1-421C-87FD-3A3A3657706F}"/>
                </a:ext>
              </a:extLst>
            </p:cNvPr>
            <p:cNvSpPr/>
            <p:nvPr/>
          </p:nvSpPr>
          <p:spPr>
            <a:xfrm>
              <a:off x="8033901" y="1523104"/>
              <a:ext cx="311994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239BF973-8F5A-49C5-8FE3-5098E5F7D4C2}"/>
                </a:ext>
              </a:extLst>
            </p:cNvPr>
            <p:cNvSpPr txBox="1"/>
            <p:nvPr/>
          </p:nvSpPr>
          <p:spPr>
            <a:xfrm>
              <a:off x="7073945" y="1523104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95100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B50AD3A-57F4-4634-8AEE-F90603C31E38}"/>
              </a:ext>
            </a:extLst>
          </p:cNvPr>
          <p:cNvSpPr txBox="1"/>
          <p:nvPr/>
        </p:nvSpPr>
        <p:spPr>
          <a:xfrm>
            <a:off x="180432" y="175889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3f</a:t>
            </a:r>
          </a:p>
        </p:txBody>
      </p: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8F3F073C-C585-4699-88CE-038C4C6B7A3D}"/>
              </a:ext>
            </a:extLst>
          </p:cNvPr>
          <p:cNvGrpSpPr/>
          <p:nvPr/>
        </p:nvGrpSpPr>
        <p:grpSpPr>
          <a:xfrm>
            <a:off x="5012935" y="1325493"/>
            <a:ext cx="2076125" cy="3433238"/>
            <a:chOff x="4804302" y="113663"/>
            <a:chExt cx="2076125" cy="3433238"/>
          </a:xfrm>
        </p:grpSpPr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C86B927B-C7C1-4C63-A1FD-5051FD5787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79950" y="113663"/>
              <a:ext cx="1800477" cy="3433238"/>
            </a:xfrm>
            <a:prstGeom prst="rect">
              <a:avLst/>
            </a:prstGeom>
          </p:spPr>
        </p:pic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974AA3FF-E0E4-42FA-8C18-9613020421BC}"/>
                </a:ext>
              </a:extLst>
            </p:cNvPr>
            <p:cNvSpPr/>
            <p:nvPr/>
          </p:nvSpPr>
          <p:spPr>
            <a:xfrm>
              <a:off x="5365255" y="1711911"/>
              <a:ext cx="1469602" cy="28075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749B24FC-0437-44E6-AA0E-21B044D2C124}"/>
                </a:ext>
              </a:extLst>
            </p:cNvPr>
            <p:cNvGrpSpPr/>
            <p:nvPr/>
          </p:nvGrpSpPr>
          <p:grpSpPr>
            <a:xfrm>
              <a:off x="5434899" y="1347388"/>
              <a:ext cx="681297" cy="288927"/>
              <a:chOff x="9620862" y="616050"/>
              <a:chExt cx="681297" cy="288927"/>
            </a:xfrm>
          </p:grpSpPr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B9E33977-3EE0-46A1-99F4-39798CD449F3}"/>
                  </a:ext>
                </a:extLst>
              </p:cNvPr>
              <p:cNvSpPr txBox="1"/>
              <p:nvPr/>
            </p:nvSpPr>
            <p:spPr bwMode="auto">
              <a:xfrm>
                <a:off x="9620862" y="777698"/>
                <a:ext cx="235641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2176D8B8-31ED-43BA-80DD-15547D2AA6D9}"/>
                  </a:ext>
                </a:extLst>
              </p:cNvPr>
              <p:cNvSpPr txBox="1"/>
              <p:nvPr/>
            </p:nvSpPr>
            <p:spPr bwMode="auto">
              <a:xfrm>
                <a:off x="10013618" y="777698"/>
                <a:ext cx="288541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直接连接符 52">
                <a:extLst>
                  <a:ext uri="{FF2B5EF4-FFF2-40B4-BE49-F238E27FC236}">
                    <a16:creationId xmlns:a16="http://schemas.microsoft.com/office/drawing/2014/main" id="{BD4C5644-66AC-4BF1-9E98-4425D84ED87F}"/>
                  </a:ext>
                </a:extLst>
              </p:cNvPr>
              <p:cNvCxnSpPr/>
              <p:nvPr/>
            </p:nvCxnSpPr>
            <p:spPr bwMode="auto">
              <a:xfrm flipV="1">
                <a:off x="9632844" y="766218"/>
                <a:ext cx="6205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7B8443C4-29C2-4DE6-8CFD-44F990129C2B}"/>
                  </a:ext>
                </a:extLst>
              </p:cNvPr>
              <p:cNvSpPr txBox="1"/>
              <p:nvPr/>
            </p:nvSpPr>
            <p:spPr bwMode="auto">
              <a:xfrm>
                <a:off x="9884172" y="616050"/>
                <a:ext cx="163506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5CD68A2C-76CD-4D5D-BD0F-3516E0004C10}"/>
                </a:ext>
              </a:extLst>
            </p:cNvPr>
            <p:cNvGrpSpPr/>
            <p:nvPr/>
          </p:nvGrpSpPr>
          <p:grpSpPr>
            <a:xfrm>
              <a:off x="6160364" y="1347387"/>
              <a:ext cx="689597" cy="294191"/>
              <a:chOff x="10492112" y="2342994"/>
              <a:chExt cx="689597" cy="294191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6D14A628-9F52-4DD0-AF0C-E94FC0B6F32C}"/>
                  </a:ext>
                </a:extLst>
              </p:cNvPr>
              <p:cNvSpPr txBox="1"/>
              <p:nvPr/>
            </p:nvSpPr>
            <p:spPr bwMode="auto">
              <a:xfrm>
                <a:off x="10492112" y="2509906"/>
                <a:ext cx="235641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FC043B1F-270E-46D4-814D-D77AF62627E3}"/>
                  </a:ext>
                </a:extLst>
              </p:cNvPr>
              <p:cNvSpPr txBox="1"/>
              <p:nvPr/>
            </p:nvSpPr>
            <p:spPr bwMode="auto">
              <a:xfrm>
                <a:off x="10893168" y="2509906"/>
                <a:ext cx="288541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E72E1036-2CBD-4772-958E-310E37D4CDF8}"/>
                  </a:ext>
                </a:extLst>
              </p:cNvPr>
              <p:cNvSpPr txBox="1"/>
              <p:nvPr/>
            </p:nvSpPr>
            <p:spPr bwMode="auto">
              <a:xfrm>
                <a:off x="10570251" y="2342994"/>
                <a:ext cx="522579" cy="12727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27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FXN2 OE</a:t>
                </a:r>
                <a:endParaRPr lang="zh-CN" altLang="en-US" sz="827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38C9F522-6DB9-463C-A368-724B5C9D6064}"/>
                </a:ext>
              </a:extLst>
            </p:cNvPr>
            <p:cNvCxnSpPr/>
            <p:nvPr/>
          </p:nvCxnSpPr>
          <p:spPr>
            <a:xfrm>
              <a:off x="6160364" y="1497556"/>
              <a:ext cx="720063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39F6D0A4-D48F-409B-B2D8-C3E198880A74}"/>
                </a:ext>
              </a:extLst>
            </p:cNvPr>
            <p:cNvCxnSpPr/>
            <p:nvPr/>
          </p:nvCxnSpPr>
          <p:spPr>
            <a:xfrm>
              <a:off x="5397102" y="1497556"/>
              <a:ext cx="720063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9D9EFC13-09B7-4537-B346-D6C145BDB2D7}"/>
                </a:ext>
              </a:extLst>
            </p:cNvPr>
            <p:cNvSpPr/>
            <p:nvPr/>
          </p:nvSpPr>
          <p:spPr bwMode="auto">
            <a:xfrm>
              <a:off x="4804302" y="1777217"/>
              <a:ext cx="501740" cy="169277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1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eclin1</a:t>
              </a:r>
              <a:endParaRPr lang="zh-CN" altLang="en-US" sz="11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F8B4B8FF-227A-4FB5-BF4C-01BB215CBBA2}"/>
              </a:ext>
            </a:extLst>
          </p:cNvPr>
          <p:cNvGrpSpPr/>
          <p:nvPr/>
        </p:nvGrpSpPr>
        <p:grpSpPr>
          <a:xfrm>
            <a:off x="896050" y="1108998"/>
            <a:ext cx="3246786" cy="1269287"/>
            <a:chOff x="896050" y="1108998"/>
            <a:chExt cx="3246786" cy="1269287"/>
          </a:xfrm>
        </p:grpSpPr>
        <p:pic>
          <p:nvPicPr>
            <p:cNvPr id="71" name="图片 70">
              <a:extLst>
                <a:ext uri="{FF2B5EF4-FFF2-40B4-BE49-F238E27FC236}">
                  <a16:creationId xmlns:a16="http://schemas.microsoft.com/office/drawing/2014/main" id="{D0318B64-4989-46AF-99E0-16AD503A6E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742"/>
            <a:stretch/>
          </p:blipFill>
          <p:spPr>
            <a:xfrm>
              <a:off x="950034" y="1108998"/>
              <a:ext cx="3138818" cy="1269287"/>
            </a:xfrm>
            <a:prstGeom prst="rect">
              <a:avLst/>
            </a:prstGeom>
          </p:spPr>
        </p:pic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9AA685B6-21CD-433F-B7CD-F8682ABAFB61}"/>
                </a:ext>
              </a:extLst>
            </p:cNvPr>
            <p:cNvGrpSpPr/>
            <p:nvPr/>
          </p:nvGrpSpPr>
          <p:grpSpPr>
            <a:xfrm>
              <a:off x="1457149" y="1108998"/>
              <a:ext cx="1268996" cy="516617"/>
              <a:chOff x="9605909" y="485093"/>
              <a:chExt cx="744679" cy="268576"/>
            </a:xfrm>
          </p:grpSpPr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DA9AE518-1C27-46F7-90AC-E999F6EBE821}"/>
                  </a:ext>
                </a:extLst>
              </p:cNvPr>
              <p:cNvSpPr txBox="1"/>
              <p:nvPr/>
            </p:nvSpPr>
            <p:spPr bwMode="auto">
              <a:xfrm>
                <a:off x="9650691" y="661460"/>
                <a:ext cx="234230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A9B01CB6-B1C6-4166-A821-69CDD08356A1}"/>
                  </a:ext>
                </a:extLst>
              </p:cNvPr>
              <p:cNvSpPr txBox="1"/>
              <p:nvPr/>
            </p:nvSpPr>
            <p:spPr bwMode="auto">
              <a:xfrm>
                <a:off x="10021172" y="661460"/>
                <a:ext cx="28784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B7F868C6-AFBB-4F2A-AB59-8961C1094A5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605909" y="614016"/>
                <a:ext cx="744679" cy="742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822C3338-C4E5-4337-8C7A-C3C3EEA37156}"/>
                  </a:ext>
                </a:extLst>
              </p:cNvPr>
              <p:cNvSpPr txBox="1"/>
              <p:nvPr/>
            </p:nvSpPr>
            <p:spPr bwMode="auto">
              <a:xfrm>
                <a:off x="9868412" y="485093"/>
                <a:ext cx="16367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8AF9ECCC-82CF-44E6-8AD3-02BC7249BD70}"/>
                </a:ext>
              </a:extLst>
            </p:cNvPr>
            <p:cNvGrpSpPr/>
            <p:nvPr/>
          </p:nvGrpSpPr>
          <p:grpSpPr>
            <a:xfrm>
              <a:off x="2873840" y="1121496"/>
              <a:ext cx="1268996" cy="516617"/>
              <a:chOff x="9605909" y="485093"/>
              <a:chExt cx="744679" cy="268576"/>
            </a:xfrm>
          </p:grpSpPr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EB8766AF-A93B-4434-BBCE-889DE01E8375}"/>
                  </a:ext>
                </a:extLst>
              </p:cNvPr>
              <p:cNvSpPr txBox="1"/>
              <p:nvPr/>
            </p:nvSpPr>
            <p:spPr bwMode="auto">
              <a:xfrm>
                <a:off x="9650691" y="661460"/>
                <a:ext cx="234230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B7417521-4FD7-45D7-9EB9-746585C49C26}"/>
                  </a:ext>
                </a:extLst>
              </p:cNvPr>
              <p:cNvSpPr txBox="1"/>
              <p:nvPr/>
            </p:nvSpPr>
            <p:spPr bwMode="auto">
              <a:xfrm>
                <a:off x="10021172" y="661460"/>
                <a:ext cx="28784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78" name="直接连接符 77">
                <a:extLst>
                  <a:ext uri="{FF2B5EF4-FFF2-40B4-BE49-F238E27FC236}">
                    <a16:creationId xmlns:a16="http://schemas.microsoft.com/office/drawing/2014/main" id="{06789B83-1C2C-484E-ADDB-378738A8F08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605909" y="614016"/>
                <a:ext cx="744679" cy="742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F991B3FE-D95B-449F-A412-7B55B24F69B8}"/>
                  </a:ext>
                </a:extLst>
              </p:cNvPr>
              <p:cNvSpPr txBox="1"/>
              <p:nvPr/>
            </p:nvSpPr>
            <p:spPr bwMode="auto">
              <a:xfrm>
                <a:off x="9689683" y="485093"/>
                <a:ext cx="521139" cy="11200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FXN2 OE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66AD1E77-EEF4-4EE7-AC28-22222838E907}"/>
                </a:ext>
              </a:extLst>
            </p:cNvPr>
            <p:cNvSpPr/>
            <p:nvPr/>
          </p:nvSpPr>
          <p:spPr>
            <a:xfrm>
              <a:off x="1433156" y="1741241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48002DC3-519A-4E40-B59A-D0C77E698A4C}"/>
                </a:ext>
              </a:extLst>
            </p:cNvPr>
            <p:cNvSpPr/>
            <p:nvPr/>
          </p:nvSpPr>
          <p:spPr bwMode="auto">
            <a:xfrm>
              <a:off x="896050" y="1806547"/>
              <a:ext cx="464359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TG7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组合 101">
            <a:extLst>
              <a:ext uri="{FF2B5EF4-FFF2-40B4-BE49-F238E27FC236}">
                <a16:creationId xmlns:a16="http://schemas.microsoft.com/office/drawing/2014/main" id="{68F96D81-A965-4792-91BF-DCAD53B8725F}"/>
              </a:ext>
            </a:extLst>
          </p:cNvPr>
          <p:cNvGrpSpPr/>
          <p:nvPr/>
        </p:nvGrpSpPr>
        <p:grpSpPr>
          <a:xfrm>
            <a:off x="8103150" y="113663"/>
            <a:ext cx="3313330" cy="2281292"/>
            <a:chOff x="8144681" y="1014215"/>
            <a:chExt cx="3313330" cy="2281292"/>
          </a:xfrm>
        </p:grpSpPr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4C2D2C19-09B9-45C3-89D0-B4EA9DE9F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44681" y="1014215"/>
              <a:ext cx="3313330" cy="2281292"/>
            </a:xfrm>
            <a:prstGeom prst="rect">
              <a:avLst/>
            </a:prstGeom>
          </p:spPr>
        </p:pic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B0C349D6-5FBF-4B0C-B74A-D54DEEB16753}"/>
                </a:ext>
              </a:extLst>
            </p:cNvPr>
            <p:cNvGrpSpPr/>
            <p:nvPr/>
          </p:nvGrpSpPr>
          <p:grpSpPr>
            <a:xfrm>
              <a:off x="8187470" y="1197240"/>
              <a:ext cx="3246786" cy="1081621"/>
              <a:chOff x="1286079" y="1295542"/>
              <a:chExt cx="3246786" cy="1081621"/>
            </a:xfrm>
          </p:grpSpPr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8072B7FF-1C17-46E5-B21B-B72CF0D22204}"/>
                  </a:ext>
                </a:extLst>
              </p:cNvPr>
              <p:cNvGrpSpPr/>
              <p:nvPr/>
            </p:nvGrpSpPr>
            <p:grpSpPr>
              <a:xfrm>
                <a:off x="1847178" y="1295542"/>
                <a:ext cx="1268996" cy="516617"/>
                <a:chOff x="9605909" y="485093"/>
                <a:chExt cx="744679" cy="268576"/>
              </a:xfrm>
            </p:grpSpPr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0909A9AD-66C0-44DD-B077-25FFD17C53CC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F58664DF-06DF-4FDC-90AA-32A40DB962A6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4" name="直接连接符 33">
                  <a:extLst>
                    <a:ext uri="{FF2B5EF4-FFF2-40B4-BE49-F238E27FC236}">
                      <a16:creationId xmlns:a16="http://schemas.microsoft.com/office/drawing/2014/main" id="{3403E6DC-B1B2-47CC-87C9-40739EB7AB3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ACCB6A12-F990-4984-83F4-89A6DCBC59F7}"/>
                    </a:ext>
                  </a:extLst>
                </p:cNvPr>
                <p:cNvSpPr txBox="1"/>
                <p:nvPr/>
              </p:nvSpPr>
              <p:spPr bwMode="auto">
                <a:xfrm>
                  <a:off x="9868412" y="485093"/>
                  <a:ext cx="16367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WT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" name="组合 37">
                <a:extLst>
                  <a:ext uri="{FF2B5EF4-FFF2-40B4-BE49-F238E27FC236}">
                    <a16:creationId xmlns:a16="http://schemas.microsoft.com/office/drawing/2014/main" id="{EA0BC3FB-F583-481E-BA1F-40FE478E9EDC}"/>
                  </a:ext>
                </a:extLst>
              </p:cNvPr>
              <p:cNvGrpSpPr/>
              <p:nvPr/>
            </p:nvGrpSpPr>
            <p:grpSpPr>
              <a:xfrm>
                <a:off x="3263869" y="1340235"/>
                <a:ext cx="1268996" cy="516617"/>
                <a:chOff x="9605909" y="485093"/>
                <a:chExt cx="744679" cy="268576"/>
              </a:xfrm>
            </p:grpSpPr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8DE72510-F753-495A-8235-556781DAD383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DBD89A3C-97D7-490A-8BF8-A51EA385E89C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接连接符 40">
                  <a:extLst>
                    <a:ext uri="{FF2B5EF4-FFF2-40B4-BE49-F238E27FC236}">
                      <a16:creationId xmlns:a16="http://schemas.microsoft.com/office/drawing/2014/main" id="{69B61B3A-2A24-4DFF-8643-80A900F93BF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78CB0BF3-2953-480D-B773-3034E1E23879}"/>
                    </a:ext>
                  </a:extLst>
                </p:cNvPr>
                <p:cNvSpPr txBox="1"/>
                <p:nvPr/>
              </p:nvSpPr>
              <p:spPr bwMode="auto">
                <a:xfrm>
                  <a:off x="9689683" y="485093"/>
                  <a:ext cx="521139" cy="11200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FXN2 OE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F5187DC0-467D-4E74-AD35-9D8522AD9B5B}"/>
                  </a:ext>
                </a:extLst>
              </p:cNvPr>
              <p:cNvSpPr/>
              <p:nvPr/>
            </p:nvSpPr>
            <p:spPr>
              <a:xfrm>
                <a:off x="1823185" y="1927785"/>
                <a:ext cx="2655696" cy="44937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79BE1F8E-E060-47C1-9CA2-BC0019A0F341}"/>
                  </a:ext>
                </a:extLst>
              </p:cNvPr>
              <p:cNvSpPr/>
              <p:nvPr/>
            </p:nvSpPr>
            <p:spPr bwMode="auto">
              <a:xfrm>
                <a:off x="1286079" y="1993091"/>
                <a:ext cx="464358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TG5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85" name="图片 84">
            <a:extLst>
              <a:ext uri="{FF2B5EF4-FFF2-40B4-BE49-F238E27FC236}">
                <a16:creationId xmlns:a16="http://schemas.microsoft.com/office/drawing/2014/main" id="{2E54E37C-9A31-4A80-8EFF-0D9FEE09229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92"/>
          <a:stretch/>
        </p:blipFill>
        <p:spPr>
          <a:xfrm>
            <a:off x="928859" y="4307435"/>
            <a:ext cx="3277114" cy="2185730"/>
          </a:xfrm>
          <a:prstGeom prst="rect">
            <a:avLst/>
          </a:prstGeom>
        </p:spPr>
      </p:pic>
      <p:grpSp>
        <p:nvGrpSpPr>
          <p:cNvPr id="88" name="组合 87">
            <a:extLst>
              <a:ext uri="{FF2B5EF4-FFF2-40B4-BE49-F238E27FC236}">
                <a16:creationId xmlns:a16="http://schemas.microsoft.com/office/drawing/2014/main" id="{C813ED27-FC00-4559-92EE-02AD03BB3A2E}"/>
              </a:ext>
            </a:extLst>
          </p:cNvPr>
          <p:cNvGrpSpPr/>
          <p:nvPr/>
        </p:nvGrpSpPr>
        <p:grpSpPr>
          <a:xfrm>
            <a:off x="1403165" y="3787124"/>
            <a:ext cx="1268996" cy="516617"/>
            <a:chOff x="9605909" y="485093"/>
            <a:chExt cx="744679" cy="268576"/>
          </a:xfrm>
        </p:grpSpPr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A8592D26-C873-4C84-A2AC-4D53BE0141B8}"/>
                </a:ext>
              </a:extLst>
            </p:cNvPr>
            <p:cNvSpPr txBox="1"/>
            <p:nvPr/>
          </p:nvSpPr>
          <p:spPr bwMode="auto">
            <a:xfrm>
              <a:off x="9650691" y="661460"/>
              <a:ext cx="234230" cy="92209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ON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25840E7-FE88-4D9C-9081-750BC2352565}"/>
                </a:ext>
              </a:extLst>
            </p:cNvPr>
            <p:cNvSpPr txBox="1"/>
            <p:nvPr/>
          </p:nvSpPr>
          <p:spPr bwMode="auto">
            <a:xfrm>
              <a:off x="10021172" y="661460"/>
              <a:ext cx="287849" cy="92209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98" name="直接连接符 97">
              <a:extLst>
                <a:ext uri="{FF2B5EF4-FFF2-40B4-BE49-F238E27FC236}">
                  <a16:creationId xmlns:a16="http://schemas.microsoft.com/office/drawing/2014/main" id="{0D0B09EA-34A1-433A-A0BA-5DB6DA04D4DE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9605909" y="614016"/>
              <a:ext cx="744679" cy="742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4ACDC3B5-3C31-4225-9BB7-689FC88010C6}"/>
                </a:ext>
              </a:extLst>
            </p:cNvPr>
            <p:cNvSpPr txBox="1"/>
            <p:nvPr/>
          </p:nvSpPr>
          <p:spPr bwMode="auto">
            <a:xfrm>
              <a:off x="9868412" y="485093"/>
              <a:ext cx="163679" cy="92209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EEAA6240-9431-4ADB-88E8-9BFA06853C92}"/>
              </a:ext>
            </a:extLst>
          </p:cNvPr>
          <p:cNvGrpSpPr/>
          <p:nvPr/>
        </p:nvGrpSpPr>
        <p:grpSpPr>
          <a:xfrm>
            <a:off x="2819856" y="3806061"/>
            <a:ext cx="1268996" cy="516617"/>
            <a:chOff x="9605909" y="485093"/>
            <a:chExt cx="744679" cy="268576"/>
          </a:xfrm>
        </p:grpSpPr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611AA4ED-CE22-42BF-9E41-C0D72212B20F}"/>
                </a:ext>
              </a:extLst>
            </p:cNvPr>
            <p:cNvSpPr txBox="1"/>
            <p:nvPr/>
          </p:nvSpPr>
          <p:spPr bwMode="auto">
            <a:xfrm>
              <a:off x="9650691" y="661460"/>
              <a:ext cx="234230" cy="92209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ON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E5B0B76D-4D5C-4DCC-99B6-FEC3371039DE}"/>
                </a:ext>
              </a:extLst>
            </p:cNvPr>
            <p:cNvSpPr txBox="1"/>
            <p:nvPr/>
          </p:nvSpPr>
          <p:spPr bwMode="auto">
            <a:xfrm>
              <a:off x="10021172" y="661460"/>
              <a:ext cx="287849" cy="92209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2970FFE9-6BA1-4826-8A9E-DA88EB928627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9605909" y="614016"/>
              <a:ext cx="744679" cy="742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5B20A5D7-C6AE-4ECD-B6FC-84B1E84C031A}"/>
                </a:ext>
              </a:extLst>
            </p:cNvPr>
            <p:cNvSpPr txBox="1"/>
            <p:nvPr/>
          </p:nvSpPr>
          <p:spPr bwMode="auto">
            <a:xfrm>
              <a:off x="9689683" y="485093"/>
              <a:ext cx="521139" cy="11200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FXN2 OE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90" name="矩形 89">
            <a:extLst>
              <a:ext uri="{FF2B5EF4-FFF2-40B4-BE49-F238E27FC236}">
                <a16:creationId xmlns:a16="http://schemas.microsoft.com/office/drawing/2014/main" id="{715A107E-638D-4D94-908A-95189E725EC3}"/>
              </a:ext>
            </a:extLst>
          </p:cNvPr>
          <p:cNvSpPr/>
          <p:nvPr/>
        </p:nvSpPr>
        <p:spPr>
          <a:xfrm>
            <a:off x="1379172" y="4419367"/>
            <a:ext cx="2655696" cy="44937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BF2F07C8-55FB-40C6-9376-E28EC18EB934}"/>
              </a:ext>
            </a:extLst>
          </p:cNvPr>
          <p:cNvSpPr/>
          <p:nvPr/>
        </p:nvSpPr>
        <p:spPr bwMode="auto">
          <a:xfrm>
            <a:off x="905127" y="4484673"/>
            <a:ext cx="338234" cy="215444"/>
          </a:xfrm>
          <a:prstGeom prst="rect">
            <a:avLst/>
          </a:prstGeom>
          <a:noFill/>
        </p:spPr>
        <p:txBody>
          <a:bodyPr wrap="none" lIns="0" tIns="0" rIns="0" bIns="0">
            <a:spAutoFit/>
          </a:bodyPr>
          <a:lstStyle/>
          <a:p>
            <a:pPr algn="ctr" defTabSz="287552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01" name="图片 100">
            <a:extLst>
              <a:ext uri="{FF2B5EF4-FFF2-40B4-BE49-F238E27FC236}">
                <a16:creationId xmlns:a16="http://schemas.microsoft.com/office/drawing/2014/main" id="{D0E7A9E2-7DE3-4EC8-BEF7-90F87DBC269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64"/>
          <a:stretch/>
        </p:blipFill>
        <p:spPr>
          <a:xfrm>
            <a:off x="8648650" y="2764923"/>
            <a:ext cx="2735564" cy="3920172"/>
          </a:xfrm>
          <a:prstGeom prst="rect">
            <a:avLst/>
          </a:prstGeom>
        </p:spPr>
      </p:pic>
      <p:grpSp>
        <p:nvGrpSpPr>
          <p:cNvPr id="117" name="组合 116">
            <a:extLst>
              <a:ext uri="{FF2B5EF4-FFF2-40B4-BE49-F238E27FC236}">
                <a16:creationId xmlns:a16="http://schemas.microsoft.com/office/drawing/2014/main" id="{DE4F7F98-3C65-48B3-888E-93DACEC4A4F3}"/>
              </a:ext>
            </a:extLst>
          </p:cNvPr>
          <p:cNvGrpSpPr/>
          <p:nvPr/>
        </p:nvGrpSpPr>
        <p:grpSpPr>
          <a:xfrm>
            <a:off x="8399401" y="5228088"/>
            <a:ext cx="2993324" cy="1081621"/>
            <a:chOff x="7886344" y="4565743"/>
            <a:chExt cx="2993324" cy="1081621"/>
          </a:xfrm>
        </p:grpSpPr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6C171DF6-AEB1-45FE-B909-A47E8E9556E9}"/>
                </a:ext>
              </a:extLst>
            </p:cNvPr>
            <p:cNvSpPr txBox="1"/>
            <p:nvPr/>
          </p:nvSpPr>
          <p:spPr bwMode="auto">
            <a:xfrm>
              <a:off x="8291610" y="4904992"/>
              <a:ext cx="399148" cy="177368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ON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D00880DD-82F5-45F4-BFFC-AF726E1292F1}"/>
                </a:ext>
              </a:extLst>
            </p:cNvPr>
            <p:cNvSpPr txBox="1"/>
            <p:nvPr/>
          </p:nvSpPr>
          <p:spPr bwMode="auto">
            <a:xfrm>
              <a:off x="8922941" y="4904992"/>
              <a:ext cx="490519" cy="177368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114" name="直接连接符 113">
              <a:extLst>
                <a:ext uri="{FF2B5EF4-FFF2-40B4-BE49-F238E27FC236}">
                  <a16:creationId xmlns:a16="http://schemas.microsoft.com/office/drawing/2014/main" id="{8E55F4B9-38C4-4ADA-83B9-A33C934C3676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8215298" y="4813732"/>
              <a:ext cx="1268996" cy="1428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3FE8C598-B5D6-4008-A593-65F8C4781C22}"/>
                </a:ext>
              </a:extLst>
            </p:cNvPr>
            <p:cNvSpPr txBox="1"/>
            <p:nvPr/>
          </p:nvSpPr>
          <p:spPr bwMode="auto">
            <a:xfrm>
              <a:off x="8662625" y="4565743"/>
              <a:ext cx="278923" cy="177368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grpSp>
          <p:nvGrpSpPr>
            <p:cNvPr id="116" name="组合 115">
              <a:extLst>
                <a:ext uri="{FF2B5EF4-FFF2-40B4-BE49-F238E27FC236}">
                  <a16:creationId xmlns:a16="http://schemas.microsoft.com/office/drawing/2014/main" id="{4627A1DD-B686-4C2A-82D5-E7CFD22D0348}"/>
                </a:ext>
              </a:extLst>
            </p:cNvPr>
            <p:cNvGrpSpPr/>
            <p:nvPr/>
          </p:nvGrpSpPr>
          <p:grpSpPr>
            <a:xfrm>
              <a:off x="9610672" y="4589026"/>
              <a:ext cx="1268996" cy="516617"/>
              <a:chOff x="9631989" y="4610436"/>
              <a:chExt cx="1268996" cy="516617"/>
            </a:xfrm>
          </p:grpSpPr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5A0BF0C4-E87F-4510-8BAF-7B17085C98C6}"/>
                  </a:ext>
                </a:extLst>
              </p:cNvPr>
              <p:cNvSpPr txBox="1"/>
              <p:nvPr/>
            </p:nvSpPr>
            <p:spPr bwMode="auto">
              <a:xfrm>
                <a:off x="9708301" y="4949685"/>
                <a:ext cx="399148" cy="177368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4BF56756-401C-4CB9-A9D2-BFF6CDA3BEC4}"/>
                  </a:ext>
                </a:extLst>
              </p:cNvPr>
              <p:cNvSpPr txBox="1"/>
              <p:nvPr/>
            </p:nvSpPr>
            <p:spPr bwMode="auto">
              <a:xfrm>
                <a:off x="10339632" y="4949685"/>
                <a:ext cx="490519" cy="177368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110" name="直接连接符 109">
                <a:extLst>
                  <a:ext uri="{FF2B5EF4-FFF2-40B4-BE49-F238E27FC236}">
                    <a16:creationId xmlns:a16="http://schemas.microsoft.com/office/drawing/2014/main" id="{899685D8-67B1-419E-82E4-DC3A841B644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631989" y="4858425"/>
                <a:ext cx="1268996" cy="14286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516A8261-D587-4E10-9413-A6E8264D91BE}"/>
                  </a:ext>
                </a:extLst>
              </p:cNvPr>
              <p:cNvSpPr txBox="1"/>
              <p:nvPr/>
            </p:nvSpPr>
            <p:spPr bwMode="auto">
              <a:xfrm>
                <a:off x="9774747" y="4610436"/>
                <a:ext cx="888065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FXN2 OE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610D93E4-6C23-4969-B07F-A1277F295C21}"/>
                </a:ext>
              </a:extLst>
            </p:cNvPr>
            <p:cNvSpPr/>
            <p:nvPr/>
          </p:nvSpPr>
          <p:spPr>
            <a:xfrm>
              <a:off x="8191305" y="5197986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94580EA3-D234-4A14-8E20-34F80FA44BC1}"/>
                </a:ext>
              </a:extLst>
            </p:cNvPr>
            <p:cNvSpPr/>
            <p:nvPr/>
          </p:nvSpPr>
          <p:spPr bwMode="auto">
            <a:xfrm>
              <a:off x="7886344" y="5263292"/>
              <a:ext cx="65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118" name="文本框 117">
            <a:extLst>
              <a:ext uri="{FF2B5EF4-FFF2-40B4-BE49-F238E27FC236}">
                <a16:creationId xmlns:a16="http://schemas.microsoft.com/office/drawing/2014/main" id="{F4C3E3F0-900E-4AAA-B454-E2CBDD719F77}"/>
              </a:ext>
            </a:extLst>
          </p:cNvPr>
          <p:cNvSpPr txBox="1"/>
          <p:nvPr/>
        </p:nvSpPr>
        <p:spPr>
          <a:xfrm>
            <a:off x="7741762" y="584869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96783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0">
            <a:extLst>
              <a:ext uri="{FF2B5EF4-FFF2-40B4-BE49-F238E27FC236}">
                <a16:creationId xmlns:a16="http://schemas.microsoft.com/office/drawing/2014/main" id="{5C482DFB-DB1D-489D-B816-0E7F7C1F76AF}"/>
              </a:ext>
            </a:extLst>
          </p:cNvPr>
          <p:cNvGrpSpPr/>
          <p:nvPr/>
        </p:nvGrpSpPr>
        <p:grpSpPr>
          <a:xfrm>
            <a:off x="651696" y="1057897"/>
            <a:ext cx="3693974" cy="1584287"/>
            <a:chOff x="651696" y="1057897"/>
            <a:chExt cx="3693974" cy="1584287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08F43FE9-4802-42C0-8F5D-39891C8F9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696" y="1057897"/>
              <a:ext cx="3693974" cy="1584287"/>
            </a:xfrm>
            <a:prstGeom prst="rect">
              <a:avLst/>
            </a:prstGeom>
          </p:spPr>
        </p:pic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A345A500-0279-4E4B-BF42-517CFF269912}"/>
                </a:ext>
              </a:extLst>
            </p:cNvPr>
            <p:cNvGrpSpPr/>
            <p:nvPr/>
          </p:nvGrpSpPr>
          <p:grpSpPr>
            <a:xfrm>
              <a:off x="806459" y="1108998"/>
              <a:ext cx="3336377" cy="1081621"/>
              <a:chOff x="806459" y="1108998"/>
              <a:chExt cx="3336377" cy="1081621"/>
            </a:xfrm>
          </p:grpSpPr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9734D44F-CD2D-431D-80E8-67EA58D93496}"/>
                  </a:ext>
                </a:extLst>
              </p:cNvPr>
              <p:cNvGrpSpPr/>
              <p:nvPr/>
            </p:nvGrpSpPr>
            <p:grpSpPr>
              <a:xfrm>
                <a:off x="1457149" y="1108998"/>
                <a:ext cx="1268996" cy="516617"/>
                <a:chOff x="9605909" y="485093"/>
                <a:chExt cx="744679" cy="268576"/>
              </a:xfrm>
            </p:grpSpPr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A42AE165-A633-491D-A572-B7002A3C8CC6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234AC12D-61AE-43FC-80A8-B415E71BD1BF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6" name="直接连接符 35">
                  <a:extLst>
                    <a:ext uri="{FF2B5EF4-FFF2-40B4-BE49-F238E27FC236}">
                      <a16:creationId xmlns:a16="http://schemas.microsoft.com/office/drawing/2014/main" id="{3892A478-6996-4CA8-8D61-2704E26CAE5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EE35B8B7-79EC-4D96-8FFC-3F3F35E9D8F8}"/>
                    </a:ext>
                  </a:extLst>
                </p:cNvPr>
                <p:cNvSpPr txBox="1"/>
                <p:nvPr/>
              </p:nvSpPr>
              <p:spPr bwMode="auto">
                <a:xfrm>
                  <a:off x="9868412" y="485093"/>
                  <a:ext cx="16367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WT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E17AD5FC-1D20-4530-A2F6-CDC345B991BA}"/>
                  </a:ext>
                </a:extLst>
              </p:cNvPr>
              <p:cNvGrpSpPr/>
              <p:nvPr/>
            </p:nvGrpSpPr>
            <p:grpSpPr>
              <a:xfrm>
                <a:off x="2873840" y="1121496"/>
                <a:ext cx="1268996" cy="516617"/>
                <a:chOff x="9605909" y="485093"/>
                <a:chExt cx="744679" cy="268576"/>
              </a:xfrm>
            </p:grpSpPr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FB0FE551-F93F-43D7-922C-009F7ADD228D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915AC9E2-B630-4CCA-AC8C-6195C1651D75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" name="直接连接符 31">
                  <a:extLst>
                    <a:ext uri="{FF2B5EF4-FFF2-40B4-BE49-F238E27FC236}">
                      <a16:creationId xmlns:a16="http://schemas.microsoft.com/office/drawing/2014/main" id="{8715E434-2052-49CD-92E8-60FF5A402AC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2D8E8585-2CD9-443B-AAA3-D9A83DDE196A}"/>
                    </a:ext>
                  </a:extLst>
                </p:cNvPr>
                <p:cNvSpPr txBox="1"/>
                <p:nvPr/>
              </p:nvSpPr>
              <p:spPr bwMode="auto">
                <a:xfrm>
                  <a:off x="9689683" y="485093"/>
                  <a:ext cx="521139" cy="11200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FXN2 OE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62BC121F-769F-4F47-800B-3B62ABA53F05}"/>
                  </a:ext>
                </a:extLst>
              </p:cNvPr>
              <p:cNvSpPr/>
              <p:nvPr/>
            </p:nvSpPr>
            <p:spPr>
              <a:xfrm>
                <a:off x="1433156" y="1741241"/>
                <a:ext cx="2655696" cy="44937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951CCFAE-093D-45E7-9DEB-4D5FF2917916}"/>
                  </a:ext>
                </a:extLst>
              </p:cNvPr>
              <p:cNvSpPr/>
              <p:nvPr/>
            </p:nvSpPr>
            <p:spPr bwMode="auto">
              <a:xfrm>
                <a:off x="806459" y="1805819"/>
                <a:ext cx="528991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INK1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84CAACFC-1C07-4C00-8974-ADB25A1C1A85}"/>
              </a:ext>
            </a:extLst>
          </p:cNvPr>
          <p:cNvGrpSpPr/>
          <p:nvPr/>
        </p:nvGrpSpPr>
        <p:grpSpPr>
          <a:xfrm>
            <a:off x="6777951" y="357527"/>
            <a:ext cx="3345995" cy="2896584"/>
            <a:chOff x="5458870" y="790340"/>
            <a:chExt cx="3345995" cy="2896584"/>
          </a:xfrm>
        </p:grpSpPr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55467E68-7C26-49A7-8658-5DBA4B8236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7587" y="790340"/>
              <a:ext cx="3267278" cy="2896584"/>
            </a:xfrm>
            <a:prstGeom prst="rect">
              <a:avLst/>
            </a:prstGeom>
          </p:spPr>
        </p:pic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FBFD61D8-954A-4656-8EC6-EB3A6DE0A5B5}"/>
                </a:ext>
              </a:extLst>
            </p:cNvPr>
            <p:cNvGrpSpPr/>
            <p:nvPr/>
          </p:nvGrpSpPr>
          <p:grpSpPr>
            <a:xfrm>
              <a:off x="5458870" y="1805819"/>
              <a:ext cx="3345995" cy="1081621"/>
              <a:chOff x="796841" y="1108998"/>
              <a:chExt cx="3345995" cy="1081621"/>
            </a:xfrm>
          </p:grpSpPr>
          <p:grpSp>
            <p:nvGrpSpPr>
              <p:cNvPr id="45" name="组合 44">
                <a:extLst>
                  <a:ext uri="{FF2B5EF4-FFF2-40B4-BE49-F238E27FC236}">
                    <a16:creationId xmlns:a16="http://schemas.microsoft.com/office/drawing/2014/main" id="{C3172F59-4E9D-44D9-AC69-AF8312F57927}"/>
                  </a:ext>
                </a:extLst>
              </p:cNvPr>
              <p:cNvGrpSpPr/>
              <p:nvPr/>
            </p:nvGrpSpPr>
            <p:grpSpPr>
              <a:xfrm>
                <a:off x="1457149" y="1108998"/>
                <a:ext cx="1268996" cy="516617"/>
                <a:chOff x="9605909" y="485093"/>
                <a:chExt cx="744679" cy="268576"/>
              </a:xfrm>
            </p:grpSpPr>
            <p:sp>
              <p:nvSpPr>
                <p:cNvPr id="53" name="文本框 52">
                  <a:extLst>
                    <a:ext uri="{FF2B5EF4-FFF2-40B4-BE49-F238E27FC236}">
                      <a16:creationId xmlns:a16="http://schemas.microsoft.com/office/drawing/2014/main" id="{E71E0574-E210-4D1E-BB62-1A75E55C6E7C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3BA7D533-E088-451B-AD00-B9DE916BED5F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5" name="直接连接符 54">
                  <a:extLst>
                    <a:ext uri="{FF2B5EF4-FFF2-40B4-BE49-F238E27FC236}">
                      <a16:creationId xmlns:a16="http://schemas.microsoft.com/office/drawing/2014/main" id="{05FDB08A-99F1-478D-A28B-0FD576C1E13B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文本框 55">
                  <a:extLst>
                    <a:ext uri="{FF2B5EF4-FFF2-40B4-BE49-F238E27FC236}">
                      <a16:creationId xmlns:a16="http://schemas.microsoft.com/office/drawing/2014/main" id="{94386B47-6073-450C-8ED3-5228616A7D20}"/>
                    </a:ext>
                  </a:extLst>
                </p:cNvPr>
                <p:cNvSpPr txBox="1"/>
                <p:nvPr/>
              </p:nvSpPr>
              <p:spPr bwMode="auto">
                <a:xfrm>
                  <a:off x="9868412" y="485093"/>
                  <a:ext cx="16367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WT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组合 45">
                <a:extLst>
                  <a:ext uri="{FF2B5EF4-FFF2-40B4-BE49-F238E27FC236}">
                    <a16:creationId xmlns:a16="http://schemas.microsoft.com/office/drawing/2014/main" id="{032B3E6A-8AD4-4363-914E-76E313F2A6B9}"/>
                  </a:ext>
                </a:extLst>
              </p:cNvPr>
              <p:cNvGrpSpPr/>
              <p:nvPr/>
            </p:nvGrpSpPr>
            <p:grpSpPr>
              <a:xfrm>
                <a:off x="2873840" y="1121496"/>
                <a:ext cx="1268996" cy="516617"/>
                <a:chOff x="9605909" y="485093"/>
                <a:chExt cx="744679" cy="268576"/>
              </a:xfrm>
            </p:grpSpPr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2BA2699F-9772-4358-A047-E024F4C65F06}"/>
                    </a:ext>
                  </a:extLst>
                </p:cNvPr>
                <p:cNvSpPr txBox="1"/>
                <p:nvPr/>
              </p:nvSpPr>
              <p:spPr bwMode="auto">
                <a:xfrm>
                  <a:off x="9650691" y="661460"/>
                  <a:ext cx="234230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ON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8F52ABCA-EF71-42C4-B690-B4478E90B9B4}"/>
                    </a:ext>
                  </a:extLst>
                </p:cNvPr>
                <p:cNvSpPr txBox="1"/>
                <p:nvPr/>
              </p:nvSpPr>
              <p:spPr bwMode="auto">
                <a:xfrm>
                  <a:off x="10021172" y="661460"/>
                  <a:ext cx="287849" cy="922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BSS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直接连接符 50">
                  <a:extLst>
                    <a:ext uri="{FF2B5EF4-FFF2-40B4-BE49-F238E27FC236}">
                      <a16:creationId xmlns:a16="http://schemas.microsoft.com/office/drawing/2014/main" id="{E6903584-D4E4-4BBF-BA6F-C8B63D023AD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9605909" y="614016"/>
                  <a:ext cx="744679" cy="7427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5DEBD668-B875-4C7F-9FEE-2DA0DBAF3E2E}"/>
                    </a:ext>
                  </a:extLst>
                </p:cNvPr>
                <p:cNvSpPr txBox="1"/>
                <p:nvPr/>
              </p:nvSpPr>
              <p:spPr bwMode="auto">
                <a:xfrm>
                  <a:off x="9689683" y="485093"/>
                  <a:ext cx="521139" cy="11200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>
                  <a:spAutoFit/>
                </a:bodyPr>
                <a:lstStyle/>
                <a:p>
                  <a:pPr algn="ctr" defTabSz="287552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14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FXN2 OE</a:t>
                  </a:r>
                  <a:endParaRPr lang="zh-CN" altLang="en-US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3C6DFEC7-2530-4510-9E81-B2B91DE46D63}"/>
                  </a:ext>
                </a:extLst>
              </p:cNvPr>
              <p:cNvSpPr/>
              <p:nvPr/>
            </p:nvSpPr>
            <p:spPr>
              <a:xfrm>
                <a:off x="1433156" y="1741241"/>
                <a:ext cx="2655696" cy="44937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23470D64-3808-4F73-BCF4-4B0F2BAE46F2}"/>
                  </a:ext>
                </a:extLst>
              </p:cNvPr>
              <p:cNvSpPr/>
              <p:nvPr/>
            </p:nvSpPr>
            <p:spPr bwMode="auto">
              <a:xfrm>
                <a:off x="796841" y="1805819"/>
                <a:ext cx="548227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rki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58" name="图片 57">
            <a:extLst>
              <a:ext uri="{FF2B5EF4-FFF2-40B4-BE49-F238E27FC236}">
                <a16:creationId xmlns:a16="http://schemas.microsoft.com/office/drawing/2014/main" id="{1BE1326B-3BE0-4FD7-BD23-0F2A02F801D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684" y="3159834"/>
            <a:ext cx="2941573" cy="3652914"/>
          </a:xfrm>
          <a:prstGeom prst="rect">
            <a:avLst/>
          </a:prstGeom>
        </p:spPr>
      </p:pic>
      <p:grpSp>
        <p:nvGrpSpPr>
          <p:cNvPr id="62" name="组合 61">
            <a:extLst>
              <a:ext uri="{FF2B5EF4-FFF2-40B4-BE49-F238E27FC236}">
                <a16:creationId xmlns:a16="http://schemas.microsoft.com/office/drawing/2014/main" id="{2643356D-BC62-41C8-A047-B4032D520F3A}"/>
              </a:ext>
            </a:extLst>
          </p:cNvPr>
          <p:cNvGrpSpPr/>
          <p:nvPr/>
        </p:nvGrpSpPr>
        <p:grpSpPr>
          <a:xfrm>
            <a:off x="3949161" y="4593978"/>
            <a:ext cx="2631126" cy="890656"/>
            <a:chOff x="1070915" y="1108998"/>
            <a:chExt cx="3071921" cy="1081621"/>
          </a:xfrm>
        </p:grpSpPr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E46329D9-0C9B-4AA3-914A-C5AEA050CB81}"/>
                </a:ext>
              </a:extLst>
            </p:cNvPr>
            <p:cNvGrpSpPr/>
            <p:nvPr/>
          </p:nvGrpSpPr>
          <p:grpSpPr>
            <a:xfrm>
              <a:off x="1457149" y="1108998"/>
              <a:ext cx="1268996" cy="516617"/>
              <a:chOff x="9605909" y="485093"/>
              <a:chExt cx="744679" cy="268576"/>
            </a:xfrm>
          </p:grpSpPr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2D8195A3-5014-49B9-BD2B-126FFD1FF186}"/>
                  </a:ext>
                </a:extLst>
              </p:cNvPr>
              <p:cNvSpPr txBox="1"/>
              <p:nvPr/>
            </p:nvSpPr>
            <p:spPr bwMode="auto">
              <a:xfrm>
                <a:off x="9650691" y="661460"/>
                <a:ext cx="234230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2C27CFBE-A927-48E9-B913-C3A525ECF9D1}"/>
                  </a:ext>
                </a:extLst>
              </p:cNvPr>
              <p:cNvSpPr txBox="1"/>
              <p:nvPr/>
            </p:nvSpPr>
            <p:spPr bwMode="auto">
              <a:xfrm>
                <a:off x="10021172" y="661460"/>
                <a:ext cx="28784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7286D17F-D119-4925-97FA-227461520B42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605909" y="614016"/>
                <a:ext cx="744679" cy="742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E88D07AC-A0FA-44CC-8CFC-44787B3AD181}"/>
                  </a:ext>
                </a:extLst>
              </p:cNvPr>
              <p:cNvSpPr txBox="1"/>
              <p:nvPr/>
            </p:nvSpPr>
            <p:spPr bwMode="auto">
              <a:xfrm>
                <a:off x="9868412" y="485093"/>
                <a:ext cx="16367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0A5E16A0-747B-44EA-8CDB-E57D0F4D109B}"/>
                </a:ext>
              </a:extLst>
            </p:cNvPr>
            <p:cNvGrpSpPr/>
            <p:nvPr/>
          </p:nvGrpSpPr>
          <p:grpSpPr>
            <a:xfrm>
              <a:off x="2873840" y="1121496"/>
              <a:ext cx="1268996" cy="516617"/>
              <a:chOff x="9605909" y="485093"/>
              <a:chExt cx="744679" cy="268576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377649A6-092D-425F-87C7-202CE5635E43}"/>
                  </a:ext>
                </a:extLst>
              </p:cNvPr>
              <p:cNvSpPr txBox="1"/>
              <p:nvPr/>
            </p:nvSpPr>
            <p:spPr bwMode="auto">
              <a:xfrm>
                <a:off x="9650691" y="661460"/>
                <a:ext cx="234230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743885B3-B9DF-4945-ADD2-9586691DDB8D}"/>
                  </a:ext>
                </a:extLst>
              </p:cNvPr>
              <p:cNvSpPr txBox="1"/>
              <p:nvPr/>
            </p:nvSpPr>
            <p:spPr bwMode="auto">
              <a:xfrm>
                <a:off x="10021172" y="661460"/>
                <a:ext cx="287849" cy="92209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AD8EE4D5-BDBC-4632-8070-B44BA6E4526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9605909" y="614016"/>
                <a:ext cx="744679" cy="742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3A3D5E07-27EF-4CF6-871D-E6112D4B93AD}"/>
                  </a:ext>
                </a:extLst>
              </p:cNvPr>
              <p:cNvSpPr txBox="1"/>
              <p:nvPr/>
            </p:nvSpPr>
            <p:spPr bwMode="auto">
              <a:xfrm>
                <a:off x="9689683" y="485093"/>
                <a:ext cx="521139" cy="11200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FXN2 OE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A3621E22-295F-4641-8850-6B06001FB755}"/>
                </a:ext>
              </a:extLst>
            </p:cNvPr>
            <p:cNvSpPr/>
            <p:nvPr/>
          </p:nvSpPr>
          <p:spPr>
            <a:xfrm>
              <a:off x="1433156" y="1741241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84113DB5-9E7C-4DD1-BD86-8C761415B1FC}"/>
                </a:ext>
              </a:extLst>
            </p:cNvPr>
            <p:cNvSpPr/>
            <p:nvPr/>
          </p:nvSpPr>
          <p:spPr bwMode="auto">
            <a:xfrm>
              <a:off x="1070915" y="1805819"/>
              <a:ext cx="75" cy="261637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76" name="文本框 75">
            <a:extLst>
              <a:ext uri="{FF2B5EF4-FFF2-40B4-BE49-F238E27FC236}">
                <a16:creationId xmlns:a16="http://schemas.microsoft.com/office/drawing/2014/main" id="{249286DA-98ED-42E2-A02E-EBC23781A1E1}"/>
              </a:ext>
            </a:extLst>
          </p:cNvPr>
          <p:cNvSpPr txBox="1"/>
          <p:nvPr/>
        </p:nvSpPr>
        <p:spPr>
          <a:xfrm>
            <a:off x="3314473" y="5112320"/>
            <a:ext cx="10245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D0BE1A80-9435-4E99-A860-1E3ED8C39B1A}"/>
              </a:ext>
            </a:extLst>
          </p:cNvPr>
          <p:cNvSpPr txBox="1"/>
          <p:nvPr/>
        </p:nvSpPr>
        <p:spPr>
          <a:xfrm>
            <a:off x="180432" y="1758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3f </a:t>
            </a:r>
          </a:p>
        </p:txBody>
      </p:sp>
    </p:spTree>
    <p:extLst>
      <p:ext uri="{BB962C8B-B14F-4D97-AF65-F5344CB8AC3E}">
        <p14:creationId xmlns:p14="http://schemas.microsoft.com/office/powerpoint/2010/main" val="16164010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AF273D6-4444-41DE-BB40-679E385AFC0E}"/>
              </a:ext>
            </a:extLst>
          </p:cNvPr>
          <p:cNvSpPr txBox="1"/>
          <p:nvPr/>
        </p:nvSpPr>
        <p:spPr>
          <a:xfrm>
            <a:off x="180432" y="17588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6d </a:t>
            </a: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1366D9C6-078A-424E-99DF-F4B26C075D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517" y="360555"/>
            <a:ext cx="2783056" cy="3155764"/>
          </a:xfrm>
          <a:prstGeom prst="rect">
            <a:avLst/>
          </a:prstGeom>
        </p:spPr>
      </p:pic>
      <p:grpSp>
        <p:nvGrpSpPr>
          <p:cNvPr id="37" name="组合 36">
            <a:extLst>
              <a:ext uri="{FF2B5EF4-FFF2-40B4-BE49-F238E27FC236}">
                <a16:creationId xmlns:a16="http://schemas.microsoft.com/office/drawing/2014/main" id="{398854E1-C245-444A-B391-60636735E1C1}"/>
              </a:ext>
            </a:extLst>
          </p:cNvPr>
          <p:cNvGrpSpPr/>
          <p:nvPr/>
        </p:nvGrpSpPr>
        <p:grpSpPr>
          <a:xfrm>
            <a:off x="260609" y="1887021"/>
            <a:ext cx="2919377" cy="489330"/>
            <a:chOff x="7361464" y="762313"/>
            <a:chExt cx="2919377" cy="489330"/>
          </a:xfrm>
        </p:grpSpPr>
        <p:sp>
          <p:nvSpPr>
            <p:cNvPr id="10" name="文本框 123">
              <a:extLst>
                <a:ext uri="{FF2B5EF4-FFF2-40B4-BE49-F238E27FC236}">
                  <a16:creationId xmlns:a16="http://schemas.microsoft.com/office/drawing/2014/main" id="{547FA4BC-195A-4849-ADDB-F9871D106E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6491" y="762313"/>
              <a:ext cx="49052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24">
              <a:extLst>
                <a:ext uri="{FF2B5EF4-FFF2-40B4-BE49-F238E27FC236}">
                  <a16:creationId xmlns:a16="http://schemas.microsoft.com/office/drawing/2014/main" id="{7555BF0E-3478-47EB-A0C0-2D55DDD6A6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61464" y="1036199"/>
              <a:ext cx="8255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2825C0F-74EE-402B-BA49-E06C2A320B34}"/>
                </a:ext>
              </a:extLst>
            </p:cNvPr>
            <p:cNvSpPr txBox="1"/>
            <p:nvPr/>
          </p:nvSpPr>
          <p:spPr bwMode="auto">
            <a:xfrm>
              <a:off x="8478051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71CFD29C-3677-4D6F-AF7B-FBDFABAF517C}"/>
                </a:ext>
              </a:extLst>
            </p:cNvPr>
            <p:cNvSpPr/>
            <p:nvPr/>
          </p:nvSpPr>
          <p:spPr bwMode="auto">
            <a:xfrm>
              <a:off x="9007009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2C1BE20-B3B3-4B37-BB82-5FAE39321676}"/>
                </a:ext>
              </a:extLst>
            </p:cNvPr>
            <p:cNvSpPr txBox="1"/>
            <p:nvPr/>
          </p:nvSpPr>
          <p:spPr bwMode="auto">
            <a:xfrm>
              <a:off x="9594108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D015A705-E0E1-49C0-8BEC-5C5D242B2691}"/>
                </a:ext>
              </a:extLst>
            </p:cNvPr>
            <p:cNvSpPr/>
            <p:nvPr/>
          </p:nvSpPr>
          <p:spPr bwMode="auto">
            <a:xfrm>
              <a:off x="10176645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75C9537-45BE-469E-9F3E-C24A388F75BF}"/>
                </a:ext>
              </a:extLst>
            </p:cNvPr>
            <p:cNvSpPr txBox="1"/>
            <p:nvPr/>
          </p:nvSpPr>
          <p:spPr bwMode="auto">
            <a:xfrm>
              <a:off x="8478051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44F0C798-66B5-42DD-A514-9432E708F408}"/>
                </a:ext>
              </a:extLst>
            </p:cNvPr>
            <p:cNvSpPr/>
            <p:nvPr/>
          </p:nvSpPr>
          <p:spPr bwMode="auto">
            <a:xfrm>
              <a:off x="9594108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F196F3A-32CE-491F-A2A9-D357D80F65B4}"/>
                </a:ext>
              </a:extLst>
            </p:cNvPr>
            <p:cNvSpPr txBox="1"/>
            <p:nvPr/>
          </p:nvSpPr>
          <p:spPr bwMode="auto">
            <a:xfrm>
              <a:off x="9007009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B11BA7AB-B03D-4AED-9E37-5A94C4D28868}"/>
                </a:ext>
              </a:extLst>
            </p:cNvPr>
            <p:cNvSpPr/>
            <p:nvPr/>
          </p:nvSpPr>
          <p:spPr bwMode="auto">
            <a:xfrm>
              <a:off x="10176645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F5D7AFE0-ABE6-4A4C-A0E8-C920052B24CC}"/>
              </a:ext>
            </a:extLst>
          </p:cNvPr>
          <p:cNvGrpSpPr/>
          <p:nvPr/>
        </p:nvGrpSpPr>
        <p:grpSpPr>
          <a:xfrm>
            <a:off x="73907" y="2376351"/>
            <a:ext cx="3444418" cy="449378"/>
            <a:chOff x="249431" y="1297742"/>
            <a:chExt cx="3444418" cy="449378"/>
          </a:xfrm>
        </p:grpSpPr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DE8F5C5-2192-4D15-9FEB-688A81E336A9}"/>
                </a:ext>
              </a:extLst>
            </p:cNvPr>
            <p:cNvSpPr txBox="1"/>
            <p:nvPr/>
          </p:nvSpPr>
          <p:spPr>
            <a:xfrm>
              <a:off x="249431" y="1332520"/>
              <a:ext cx="783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G5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ED0C623D-43AD-410D-BD2D-346906F1FD0D}"/>
                </a:ext>
              </a:extLst>
            </p:cNvPr>
            <p:cNvSpPr/>
            <p:nvPr/>
          </p:nvSpPr>
          <p:spPr>
            <a:xfrm>
              <a:off x="1038153" y="1297742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43" name="图片 42">
            <a:extLst>
              <a:ext uri="{FF2B5EF4-FFF2-40B4-BE49-F238E27FC236}">
                <a16:creationId xmlns:a16="http://schemas.microsoft.com/office/drawing/2014/main" id="{848D6635-82BD-4BEA-A88B-EBB0293F93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4882" y="360555"/>
            <a:ext cx="3028116" cy="3155764"/>
          </a:xfrm>
          <a:prstGeom prst="rect">
            <a:avLst/>
          </a:prstGeom>
        </p:spPr>
      </p:pic>
      <p:grpSp>
        <p:nvGrpSpPr>
          <p:cNvPr id="61" name="组合 60">
            <a:extLst>
              <a:ext uri="{FF2B5EF4-FFF2-40B4-BE49-F238E27FC236}">
                <a16:creationId xmlns:a16="http://schemas.microsoft.com/office/drawing/2014/main" id="{969F5848-50E4-47CA-AE71-87DF32CD61E1}"/>
              </a:ext>
            </a:extLst>
          </p:cNvPr>
          <p:cNvGrpSpPr/>
          <p:nvPr/>
        </p:nvGrpSpPr>
        <p:grpSpPr>
          <a:xfrm>
            <a:off x="3996666" y="717743"/>
            <a:ext cx="3444418" cy="978508"/>
            <a:chOff x="4712280" y="487550"/>
            <a:chExt cx="3444418" cy="978508"/>
          </a:xfrm>
        </p:grpSpPr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77AF340C-FE8A-42FE-B88F-208E1E10515F}"/>
                </a:ext>
              </a:extLst>
            </p:cNvPr>
            <p:cNvGrpSpPr/>
            <p:nvPr/>
          </p:nvGrpSpPr>
          <p:grpSpPr>
            <a:xfrm>
              <a:off x="5056870" y="487550"/>
              <a:ext cx="2919377" cy="489330"/>
              <a:chOff x="7361464" y="762313"/>
              <a:chExt cx="2919377" cy="489330"/>
            </a:xfrm>
          </p:grpSpPr>
          <p:sp>
            <p:nvSpPr>
              <p:cNvPr id="45" name="文本框 123">
                <a:extLst>
                  <a:ext uri="{FF2B5EF4-FFF2-40B4-BE49-F238E27FC236}">
                    <a16:creationId xmlns:a16="http://schemas.microsoft.com/office/drawing/2014/main" id="{9F6ED4B2-74AA-459D-9A7C-FEB0E943CD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96491" y="762313"/>
                <a:ext cx="490520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>
                <a:spAutoFit/>
              </a:bodyPr>
              <a:lstStyle>
                <a:lvl1pPr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defTabSz="376117" eaLnBrk="1" hangingPunct="1"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BSS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124">
                <a:extLst>
                  <a:ext uri="{FF2B5EF4-FFF2-40B4-BE49-F238E27FC236}">
                    <a16:creationId xmlns:a16="http://schemas.microsoft.com/office/drawing/2014/main" id="{0D4ED173-FA79-4191-B249-1880145361B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361464" y="1036199"/>
                <a:ext cx="82554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>
                <a:spAutoFit/>
              </a:bodyPr>
              <a:lstStyle>
                <a:lvl1pPr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defTabSz="608013" eaLnBrk="0" fontAlgn="base" hangingPunct="0">
                  <a:spcBef>
                    <a:spcPct val="0"/>
                  </a:spcBef>
                  <a:spcAft>
                    <a:spcPct val="0"/>
                  </a:spcAft>
                  <a:defRPr sz="23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defTabSz="376117" eaLnBrk="1" hangingPunct="1"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-1-IN-1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7C2B8F99-C880-4700-BEE1-664BEC513CF0}"/>
                  </a:ext>
                </a:extLst>
              </p:cNvPr>
              <p:cNvSpPr txBox="1"/>
              <p:nvPr/>
            </p:nvSpPr>
            <p:spPr bwMode="auto">
              <a:xfrm>
                <a:off x="8478051" y="1006102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 algn="ctr"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dirty="0">
                    <a:solidFill>
                      <a:srgbClr val="FF0000"/>
                    </a:solidFill>
                    <a:ea typeface="+mn-ea"/>
                  </a:rPr>
                  <a:t>−</a:t>
                </a:r>
                <a:endParaRPr lang="zh-CN" altLang="en-US" sz="1400" dirty="0">
                  <a:solidFill>
                    <a:srgbClr val="FF0000"/>
                  </a:solidFill>
                  <a:ea typeface="+mn-ea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00F0E976-611F-4BB8-A221-94136BD2E7DD}"/>
                  </a:ext>
                </a:extLst>
              </p:cNvPr>
              <p:cNvSpPr/>
              <p:nvPr/>
            </p:nvSpPr>
            <p:spPr bwMode="auto">
              <a:xfrm>
                <a:off x="9007009" y="1006102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D9BDC55-01F9-4259-A1A3-722585180F3B}"/>
                  </a:ext>
                </a:extLst>
              </p:cNvPr>
              <p:cNvSpPr txBox="1"/>
              <p:nvPr/>
            </p:nvSpPr>
            <p:spPr bwMode="auto">
              <a:xfrm>
                <a:off x="9594108" y="1006102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 algn="ctr"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dirty="0">
                    <a:solidFill>
                      <a:srgbClr val="FF0000"/>
                    </a:solidFill>
                    <a:ea typeface="+mn-ea"/>
                  </a:rPr>
                  <a:t>−</a:t>
                </a:r>
                <a:endParaRPr lang="zh-CN" altLang="en-US" sz="1400" dirty="0">
                  <a:solidFill>
                    <a:srgbClr val="FF0000"/>
                  </a:solidFill>
                  <a:ea typeface="+mn-ea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44BFBE93-762E-4F02-8675-C2186B103D00}"/>
                  </a:ext>
                </a:extLst>
              </p:cNvPr>
              <p:cNvSpPr/>
              <p:nvPr/>
            </p:nvSpPr>
            <p:spPr bwMode="auto">
              <a:xfrm>
                <a:off x="10176645" y="1006102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450D9548-176B-4B38-945B-3324DED5AF1B}"/>
                  </a:ext>
                </a:extLst>
              </p:cNvPr>
              <p:cNvSpPr txBox="1"/>
              <p:nvPr/>
            </p:nvSpPr>
            <p:spPr bwMode="auto">
              <a:xfrm>
                <a:off x="8478051" y="786391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 algn="ctr"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dirty="0">
                    <a:solidFill>
                      <a:srgbClr val="FF0000"/>
                    </a:solidFill>
                    <a:ea typeface="+mn-ea"/>
                  </a:rPr>
                  <a:t>−</a:t>
                </a:r>
                <a:endParaRPr lang="zh-CN" altLang="en-US" sz="1400" dirty="0">
                  <a:solidFill>
                    <a:srgbClr val="FF0000"/>
                  </a:solidFill>
                  <a:ea typeface="+mn-ea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7C971538-F770-460A-B5CE-2C23A587E694}"/>
                  </a:ext>
                </a:extLst>
              </p:cNvPr>
              <p:cNvSpPr/>
              <p:nvPr/>
            </p:nvSpPr>
            <p:spPr bwMode="auto">
              <a:xfrm>
                <a:off x="9594108" y="786391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FC7A1F47-75A9-4320-8D60-64F2D1E59DE9}"/>
                  </a:ext>
                </a:extLst>
              </p:cNvPr>
              <p:cNvSpPr txBox="1"/>
              <p:nvPr/>
            </p:nvSpPr>
            <p:spPr bwMode="auto">
              <a:xfrm>
                <a:off x="9007009" y="786391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 algn="ctr"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dirty="0">
                    <a:solidFill>
                      <a:srgbClr val="FF0000"/>
                    </a:solidFill>
                    <a:ea typeface="+mn-ea"/>
                  </a:rPr>
                  <a:t>−</a:t>
                </a:r>
                <a:endParaRPr lang="zh-CN" altLang="en-US" sz="1400" dirty="0">
                  <a:solidFill>
                    <a:srgbClr val="FF0000"/>
                  </a:solidFill>
                  <a:ea typeface="+mn-ea"/>
                </a:endParaRPr>
              </a:p>
            </p:txBody>
          </p: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B26121AB-5809-47A0-9782-2AA11B1E4C01}"/>
                  </a:ext>
                </a:extLst>
              </p:cNvPr>
              <p:cNvSpPr/>
              <p:nvPr/>
            </p:nvSpPr>
            <p:spPr bwMode="auto">
              <a:xfrm>
                <a:off x="10176645" y="786391"/>
                <a:ext cx="104196" cy="215444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+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9F7B80E6-39FE-4300-AF72-514B7D51CC5E}"/>
                </a:ext>
              </a:extLst>
            </p:cNvPr>
            <p:cNvGrpSpPr/>
            <p:nvPr/>
          </p:nvGrpSpPr>
          <p:grpSpPr>
            <a:xfrm>
              <a:off x="4712280" y="1016680"/>
              <a:ext cx="3444418" cy="449378"/>
              <a:chOff x="249431" y="1297742"/>
              <a:chExt cx="3444418" cy="449378"/>
            </a:xfrm>
          </p:grpSpPr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441D2B1A-37F7-44F4-85D3-67BBFD7C6CB7}"/>
                  </a:ext>
                </a:extLst>
              </p:cNvPr>
              <p:cNvSpPr txBox="1"/>
              <p:nvPr/>
            </p:nvSpPr>
            <p:spPr>
              <a:xfrm>
                <a:off x="249431" y="1332520"/>
                <a:ext cx="7830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G7</a:t>
                </a:r>
                <a:endParaRPr lang="zh-CN" altLang="en-US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CD73B9B0-5450-432A-AFC9-9F45C0984CC8}"/>
                  </a:ext>
                </a:extLst>
              </p:cNvPr>
              <p:cNvSpPr/>
              <p:nvPr/>
            </p:nvSpPr>
            <p:spPr>
              <a:xfrm>
                <a:off x="1038153" y="1297742"/>
                <a:ext cx="2655696" cy="449378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pic>
        <p:nvPicPr>
          <p:cNvPr id="59" name="图片 58">
            <a:extLst>
              <a:ext uri="{FF2B5EF4-FFF2-40B4-BE49-F238E27FC236}">
                <a16:creationId xmlns:a16="http://schemas.microsoft.com/office/drawing/2014/main" id="{4E69A01C-2298-41F1-B098-970DDA506D9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2104" y="676343"/>
            <a:ext cx="3771419" cy="2495969"/>
          </a:xfrm>
          <a:prstGeom prst="rect">
            <a:avLst/>
          </a:prstGeom>
        </p:spPr>
      </p:pic>
      <p:grpSp>
        <p:nvGrpSpPr>
          <p:cNvPr id="78" name="组合 77">
            <a:extLst>
              <a:ext uri="{FF2B5EF4-FFF2-40B4-BE49-F238E27FC236}">
                <a16:creationId xmlns:a16="http://schemas.microsoft.com/office/drawing/2014/main" id="{A2EF778F-2C59-4626-B163-5A50BC94B09C}"/>
              </a:ext>
            </a:extLst>
          </p:cNvPr>
          <p:cNvGrpSpPr/>
          <p:nvPr/>
        </p:nvGrpSpPr>
        <p:grpSpPr>
          <a:xfrm>
            <a:off x="7732124" y="1036986"/>
            <a:ext cx="3593058" cy="489330"/>
            <a:chOff x="8326074" y="1009796"/>
            <a:chExt cx="2999108" cy="489330"/>
          </a:xfrm>
        </p:grpSpPr>
        <p:sp>
          <p:nvSpPr>
            <p:cNvPr id="68" name="文本框 123">
              <a:extLst>
                <a:ext uri="{FF2B5EF4-FFF2-40B4-BE49-F238E27FC236}">
                  <a16:creationId xmlns:a16="http://schemas.microsoft.com/office/drawing/2014/main" id="{35AD6AA5-5957-4477-A423-2BBCD50A78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70251" y="1009796"/>
              <a:ext cx="50391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124">
              <a:extLst>
                <a:ext uri="{FF2B5EF4-FFF2-40B4-BE49-F238E27FC236}">
                  <a16:creationId xmlns:a16="http://schemas.microsoft.com/office/drawing/2014/main" id="{EB4B2DC9-7D1E-4350-9439-539E4E0EB8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26074" y="1283682"/>
              <a:ext cx="84809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81DD42B-CDC9-41CC-A522-A367A2751690}"/>
                </a:ext>
              </a:extLst>
            </p:cNvPr>
            <p:cNvSpPr txBox="1"/>
            <p:nvPr/>
          </p:nvSpPr>
          <p:spPr bwMode="auto">
            <a:xfrm>
              <a:off x="9473156" y="1253585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9C2B4D5F-CB69-4B7E-8182-A8E708EBA793}"/>
                </a:ext>
              </a:extLst>
            </p:cNvPr>
            <p:cNvSpPr/>
            <p:nvPr/>
          </p:nvSpPr>
          <p:spPr bwMode="auto">
            <a:xfrm>
              <a:off x="10016560" y="1253585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90A1E403-41CF-4C24-A871-3067DDD7FE35}"/>
                </a:ext>
              </a:extLst>
            </p:cNvPr>
            <p:cNvSpPr txBox="1"/>
            <p:nvPr/>
          </p:nvSpPr>
          <p:spPr bwMode="auto">
            <a:xfrm>
              <a:off x="10619694" y="1253585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A5D4AFF9-66F0-493A-B5ED-F151045ADCBD}"/>
                </a:ext>
              </a:extLst>
            </p:cNvPr>
            <p:cNvSpPr/>
            <p:nvPr/>
          </p:nvSpPr>
          <p:spPr bwMode="auto">
            <a:xfrm>
              <a:off x="11218140" y="1253585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FD6745F1-8D11-4DCB-808E-BAD8748AC868}"/>
                </a:ext>
              </a:extLst>
            </p:cNvPr>
            <p:cNvSpPr txBox="1"/>
            <p:nvPr/>
          </p:nvSpPr>
          <p:spPr bwMode="auto">
            <a:xfrm>
              <a:off x="9473156" y="1033874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8593C1CA-809D-47EF-BD51-ADF53A5B76D9}"/>
                </a:ext>
              </a:extLst>
            </p:cNvPr>
            <p:cNvSpPr/>
            <p:nvPr/>
          </p:nvSpPr>
          <p:spPr bwMode="auto">
            <a:xfrm>
              <a:off x="10619694" y="1033874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9252FE03-13EF-4E8A-B7BA-F38C6AA64BAE}"/>
                </a:ext>
              </a:extLst>
            </p:cNvPr>
            <p:cNvSpPr txBox="1"/>
            <p:nvPr/>
          </p:nvSpPr>
          <p:spPr bwMode="auto">
            <a:xfrm>
              <a:off x="10016560" y="1033874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E413A750-4F1D-4917-ABA1-63F33037E3B3}"/>
                </a:ext>
              </a:extLst>
            </p:cNvPr>
            <p:cNvSpPr/>
            <p:nvPr/>
          </p:nvSpPr>
          <p:spPr bwMode="auto">
            <a:xfrm>
              <a:off x="11218140" y="1033874"/>
              <a:ext cx="107042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66" name="文本框 65">
            <a:extLst>
              <a:ext uri="{FF2B5EF4-FFF2-40B4-BE49-F238E27FC236}">
                <a16:creationId xmlns:a16="http://schemas.microsoft.com/office/drawing/2014/main" id="{9D017B49-48FE-4128-9602-FBA3A901ADC5}"/>
              </a:ext>
            </a:extLst>
          </p:cNvPr>
          <p:cNvSpPr txBox="1"/>
          <p:nvPr/>
        </p:nvSpPr>
        <p:spPr>
          <a:xfrm>
            <a:off x="7907174" y="156440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2B0DDDED-58D5-4E0D-84DF-B357446DA757}"/>
              </a:ext>
            </a:extLst>
          </p:cNvPr>
          <p:cNvSpPr/>
          <p:nvPr/>
        </p:nvSpPr>
        <p:spPr>
          <a:xfrm>
            <a:off x="8807615" y="1538768"/>
            <a:ext cx="2728225" cy="44937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3E5E3825-BE55-42A1-A116-F0C9673808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661" y="4164410"/>
            <a:ext cx="3205649" cy="2658714"/>
          </a:xfrm>
          <a:prstGeom prst="rect">
            <a:avLst/>
          </a:prstGeom>
        </p:spPr>
      </p:pic>
      <p:grpSp>
        <p:nvGrpSpPr>
          <p:cNvPr id="81" name="组合 80">
            <a:extLst>
              <a:ext uri="{FF2B5EF4-FFF2-40B4-BE49-F238E27FC236}">
                <a16:creationId xmlns:a16="http://schemas.microsoft.com/office/drawing/2014/main" id="{AA78CEE5-DF8E-4DDD-8386-66C88131C569}"/>
              </a:ext>
            </a:extLst>
          </p:cNvPr>
          <p:cNvGrpSpPr/>
          <p:nvPr/>
        </p:nvGrpSpPr>
        <p:grpSpPr>
          <a:xfrm>
            <a:off x="372264" y="3953353"/>
            <a:ext cx="2919377" cy="489330"/>
            <a:chOff x="7361464" y="762313"/>
            <a:chExt cx="2919377" cy="489330"/>
          </a:xfrm>
        </p:grpSpPr>
        <p:sp>
          <p:nvSpPr>
            <p:cNvPr id="82" name="文本框 123">
              <a:extLst>
                <a:ext uri="{FF2B5EF4-FFF2-40B4-BE49-F238E27FC236}">
                  <a16:creationId xmlns:a16="http://schemas.microsoft.com/office/drawing/2014/main" id="{96158AC5-8C59-403C-82B6-E13AADC414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6491" y="762313"/>
              <a:ext cx="49052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124">
              <a:extLst>
                <a:ext uri="{FF2B5EF4-FFF2-40B4-BE49-F238E27FC236}">
                  <a16:creationId xmlns:a16="http://schemas.microsoft.com/office/drawing/2014/main" id="{98691F0A-6A19-47EA-B991-ADF2ACD6C9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61464" y="1036199"/>
              <a:ext cx="8255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0D7900B3-B5F4-40DC-A4D0-4E87962FDD21}"/>
                </a:ext>
              </a:extLst>
            </p:cNvPr>
            <p:cNvSpPr txBox="1"/>
            <p:nvPr/>
          </p:nvSpPr>
          <p:spPr bwMode="auto">
            <a:xfrm>
              <a:off x="8478051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1D110306-CF1D-4E66-8FE6-E2FC6EC924F7}"/>
                </a:ext>
              </a:extLst>
            </p:cNvPr>
            <p:cNvSpPr/>
            <p:nvPr/>
          </p:nvSpPr>
          <p:spPr bwMode="auto">
            <a:xfrm>
              <a:off x="9007009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C3E132F3-4D81-4483-AABC-D78ADFCA336F}"/>
                </a:ext>
              </a:extLst>
            </p:cNvPr>
            <p:cNvSpPr txBox="1"/>
            <p:nvPr/>
          </p:nvSpPr>
          <p:spPr bwMode="auto">
            <a:xfrm>
              <a:off x="9594108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9A3E163B-9E0C-44EC-952D-345775C36A5A}"/>
                </a:ext>
              </a:extLst>
            </p:cNvPr>
            <p:cNvSpPr/>
            <p:nvPr/>
          </p:nvSpPr>
          <p:spPr bwMode="auto">
            <a:xfrm>
              <a:off x="10176645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C59B6C80-4F2F-472F-B5C1-1F1BF42CAECE}"/>
                </a:ext>
              </a:extLst>
            </p:cNvPr>
            <p:cNvSpPr txBox="1"/>
            <p:nvPr/>
          </p:nvSpPr>
          <p:spPr bwMode="auto">
            <a:xfrm>
              <a:off x="8478051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89" name="矩形 88">
              <a:extLst>
                <a:ext uri="{FF2B5EF4-FFF2-40B4-BE49-F238E27FC236}">
                  <a16:creationId xmlns:a16="http://schemas.microsoft.com/office/drawing/2014/main" id="{BDDF3E02-A3EC-4251-BF79-6ED2F1544893}"/>
                </a:ext>
              </a:extLst>
            </p:cNvPr>
            <p:cNvSpPr/>
            <p:nvPr/>
          </p:nvSpPr>
          <p:spPr bwMode="auto">
            <a:xfrm>
              <a:off x="9594108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86E90582-117C-464A-B28A-C8E6BDD55D43}"/>
                </a:ext>
              </a:extLst>
            </p:cNvPr>
            <p:cNvSpPr txBox="1"/>
            <p:nvPr/>
          </p:nvSpPr>
          <p:spPr bwMode="auto">
            <a:xfrm>
              <a:off x="9007009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CFC71E45-9342-4191-B8AC-F972119AF026}"/>
                </a:ext>
              </a:extLst>
            </p:cNvPr>
            <p:cNvSpPr/>
            <p:nvPr/>
          </p:nvSpPr>
          <p:spPr bwMode="auto">
            <a:xfrm>
              <a:off x="10176645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pic>
        <p:nvPicPr>
          <p:cNvPr id="96" name="图片 95">
            <a:extLst>
              <a:ext uri="{FF2B5EF4-FFF2-40B4-BE49-F238E27FC236}">
                <a16:creationId xmlns:a16="http://schemas.microsoft.com/office/drawing/2014/main" id="{D55E4FA0-594E-449E-959E-D81A50ECAEA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1221" y="4272834"/>
            <a:ext cx="3500509" cy="2074740"/>
          </a:xfrm>
          <a:prstGeom prst="rect">
            <a:avLst/>
          </a:prstGeom>
        </p:spPr>
      </p:pic>
      <p:grpSp>
        <p:nvGrpSpPr>
          <p:cNvPr id="97" name="组合 96">
            <a:extLst>
              <a:ext uri="{FF2B5EF4-FFF2-40B4-BE49-F238E27FC236}">
                <a16:creationId xmlns:a16="http://schemas.microsoft.com/office/drawing/2014/main" id="{2EA1FC35-0421-446A-9786-F7412E7015C2}"/>
              </a:ext>
            </a:extLst>
          </p:cNvPr>
          <p:cNvGrpSpPr/>
          <p:nvPr/>
        </p:nvGrpSpPr>
        <p:grpSpPr>
          <a:xfrm>
            <a:off x="3731500" y="4922392"/>
            <a:ext cx="3556882" cy="489330"/>
            <a:chOff x="7361464" y="762313"/>
            <a:chExt cx="2919377" cy="489330"/>
          </a:xfrm>
        </p:grpSpPr>
        <p:sp>
          <p:nvSpPr>
            <p:cNvPr id="98" name="文本框 123">
              <a:extLst>
                <a:ext uri="{FF2B5EF4-FFF2-40B4-BE49-F238E27FC236}">
                  <a16:creationId xmlns:a16="http://schemas.microsoft.com/office/drawing/2014/main" id="{789FB2E3-76EE-4F64-BE7B-709EA4E3ED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6491" y="762313"/>
              <a:ext cx="49052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124">
              <a:extLst>
                <a:ext uri="{FF2B5EF4-FFF2-40B4-BE49-F238E27FC236}">
                  <a16:creationId xmlns:a16="http://schemas.microsoft.com/office/drawing/2014/main" id="{6F7E2F66-D0F6-4E6B-B4A3-262BD7E1EF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61464" y="1036199"/>
              <a:ext cx="8255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176CA32B-F940-43F8-A6AF-D3725DF1366E}"/>
                </a:ext>
              </a:extLst>
            </p:cNvPr>
            <p:cNvSpPr txBox="1"/>
            <p:nvPr/>
          </p:nvSpPr>
          <p:spPr bwMode="auto">
            <a:xfrm>
              <a:off x="8478051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91BFFBCB-034E-484F-A8F7-9B3FDCA046AE}"/>
                </a:ext>
              </a:extLst>
            </p:cNvPr>
            <p:cNvSpPr/>
            <p:nvPr/>
          </p:nvSpPr>
          <p:spPr bwMode="auto">
            <a:xfrm>
              <a:off x="9007009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9810E5A9-F370-43F5-A4DF-18C1BE8EB38E}"/>
                </a:ext>
              </a:extLst>
            </p:cNvPr>
            <p:cNvSpPr txBox="1"/>
            <p:nvPr/>
          </p:nvSpPr>
          <p:spPr bwMode="auto">
            <a:xfrm>
              <a:off x="9594108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914CC55F-C9E0-40A5-A909-D0827498CAFF}"/>
                </a:ext>
              </a:extLst>
            </p:cNvPr>
            <p:cNvSpPr/>
            <p:nvPr/>
          </p:nvSpPr>
          <p:spPr bwMode="auto">
            <a:xfrm>
              <a:off x="10176645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C1A9C4D5-FF44-4370-BCBE-22D496C0D0E3}"/>
                </a:ext>
              </a:extLst>
            </p:cNvPr>
            <p:cNvSpPr txBox="1"/>
            <p:nvPr/>
          </p:nvSpPr>
          <p:spPr bwMode="auto">
            <a:xfrm>
              <a:off x="8478051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1D434EF8-B4AF-45EC-8B5E-6B3ED2D03772}"/>
                </a:ext>
              </a:extLst>
            </p:cNvPr>
            <p:cNvSpPr/>
            <p:nvPr/>
          </p:nvSpPr>
          <p:spPr bwMode="auto">
            <a:xfrm>
              <a:off x="9594108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D5847668-1B1E-4EC8-BE54-D49CE26F3DE1}"/>
                </a:ext>
              </a:extLst>
            </p:cNvPr>
            <p:cNvSpPr txBox="1"/>
            <p:nvPr/>
          </p:nvSpPr>
          <p:spPr bwMode="auto">
            <a:xfrm>
              <a:off x="9007009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1A3C6820-0A17-4E4F-9F61-8137ED8C61D9}"/>
                </a:ext>
              </a:extLst>
            </p:cNvPr>
            <p:cNvSpPr/>
            <p:nvPr/>
          </p:nvSpPr>
          <p:spPr bwMode="auto">
            <a:xfrm>
              <a:off x="10176645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5900DC26-4B8A-4E12-BDC1-FE4E2B2F97FD}"/>
              </a:ext>
            </a:extLst>
          </p:cNvPr>
          <p:cNvGrpSpPr/>
          <p:nvPr/>
        </p:nvGrpSpPr>
        <p:grpSpPr>
          <a:xfrm>
            <a:off x="3731500" y="5480259"/>
            <a:ext cx="3827659" cy="449378"/>
            <a:chOff x="351367" y="1297742"/>
            <a:chExt cx="3342482" cy="449378"/>
          </a:xfrm>
        </p:grpSpPr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13C03C82-57ED-4591-AC33-2C5ADDF14B86}"/>
                </a:ext>
              </a:extLst>
            </p:cNvPr>
            <p:cNvSpPr txBox="1"/>
            <p:nvPr/>
          </p:nvSpPr>
          <p:spPr>
            <a:xfrm>
              <a:off x="351367" y="1333181"/>
              <a:ext cx="5420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659D2646-385E-45B6-BA5E-DCA52520C919}"/>
                </a:ext>
              </a:extLst>
            </p:cNvPr>
            <p:cNvSpPr/>
            <p:nvPr/>
          </p:nvSpPr>
          <p:spPr>
            <a:xfrm>
              <a:off x="1038153" y="1297742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8" name="组合 107">
            <a:extLst>
              <a:ext uri="{FF2B5EF4-FFF2-40B4-BE49-F238E27FC236}">
                <a16:creationId xmlns:a16="http://schemas.microsoft.com/office/drawing/2014/main" id="{959874F8-7CE0-4AD5-B8D3-FF6FB0990429}"/>
              </a:ext>
            </a:extLst>
          </p:cNvPr>
          <p:cNvGrpSpPr/>
          <p:nvPr/>
        </p:nvGrpSpPr>
        <p:grpSpPr>
          <a:xfrm>
            <a:off x="31435" y="4522166"/>
            <a:ext cx="3827659" cy="449378"/>
            <a:chOff x="351367" y="1297742"/>
            <a:chExt cx="3342482" cy="449378"/>
          </a:xfrm>
        </p:grpSpPr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97C82F50-20D5-4723-AB85-E3D7EF891E9C}"/>
                </a:ext>
              </a:extLst>
            </p:cNvPr>
            <p:cNvSpPr txBox="1"/>
            <p:nvPr/>
          </p:nvSpPr>
          <p:spPr>
            <a:xfrm>
              <a:off x="351367" y="1333181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1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02D4ACD3-8EF0-4C19-B20C-74E65626F29F}"/>
                </a:ext>
              </a:extLst>
            </p:cNvPr>
            <p:cNvSpPr/>
            <p:nvPr/>
          </p:nvSpPr>
          <p:spPr>
            <a:xfrm>
              <a:off x="1038153" y="1297742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12" name="图片 111">
            <a:extLst>
              <a:ext uri="{FF2B5EF4-FFF2-40B4-BE49-F238E27FC236}">
                <a16:creationId xmlns:a16="http://schemas.microsoft.com/office/drawing/2014/main" id="{38131FE9-5CD8-4B84-BF02-C31E6A24D33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3689" y="3460796"/>
            <a:ext cx="2504232" cy="3449580"/>
          </a:xfrm>
          <a:prstGeom prst="rect">
            <a:avLst/>
          </a:prstGeom>
        </p:spPr>
      </p:pic>
      <p:grpSp>
        <p:nvGrpSpPr>
          <p:cNvPr id="113" name="组合 112">
            <a:extLst>
              <a:ext uri="{FF2B5EF4-FFF2-40B4-BE49-F238E27FC236}">
                <a16:creationId xmlns:a16="http://schemas.microsoft.com/office/drawing/2014/main" id="{36082FC5-C0D4-49F9-B358-4B3791B47CDA}"/>
              </a:ext>
            </a:extLst>
          </p:cNvPr>
          <p:cNvGrpSpPr/>
          <p:nvPr/>
        </p:nvGrpSpPr>
        <p:grpSpPr>
          <a:xfrm>
            <a:off x="8758347" y="4648506"/>
            <a:ext cx="2401874" cy="489330"/>
            <a:chOff x="7361464" y="762313"/>
            <a:chExt cx="2919377" cy="489330"/>
          </a:xfrm>
        </p:grpSpPr>
        <p:sp>
          <p:nvSpPr>
            <p:cNvPr id="114" name="文本框 123">
              <a:extLst>
                <a:ext uri="{FF2B5EF4-FFF2-40B4-BE49-F238E27FC236}">
                  <a16:creationId xmlns:a16="http://schemas.microsoft.com/office/drawing/2014/main" id="{62241B3C-5260-4469-9BDE-AFA3109FA2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6491" y="762313"/>
              <a:ext cx="49052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BSS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24">
              <a:extLst>
                <a:ext uri="{FF2B5EF4-FFF2-40B4-BE49-F238E27FC236}">
                  <a16:creationId xmlns:a16="http://schemas.microsoft.com/office/drawing/2014/main" id="{BACE2A81-AA75-473C-B771-72A1A8D6E6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61464" y="1036199"/>
              <a:ext cx="82554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defTabSz="608013" eaLnBrk="0" fontAlgn="base" hangingPunct="0">
                <a:spcBef>
                  <a:spcPct val="0"/>
                </a:spcBef>
                <a:spcAft>
                  <a:spcPct val="0"/>
                </a:spcAft>
                <a:defRPr sz="23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defTabSz="376117" eaLnBrk="1" hangingPunct="1"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07A00005-589F-484E-A50A-931F7B4BCAA1}"/>
                </a:ext>
              </a:extLst>
            </p:cNvPr>
            <p:cNvSpPr txBox="1"/>
            <p:nvPr/>
          </p:nvSpPr>
          <p:spPr bwMode="auto">
            <a:xfrm>
              <a:off x="8478051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46D9983A-F642-4176-B7CF-24FD001F67CF}"/>
                </a:ext>
              </a:extLst>
            </p:cNvPr>
            <p:cNvSpPr/>
            <p:nvPr/>
          </p:nvSpPr>
          <p:spPr bwMode="auto">
            <a:xfrm>
              <a:off x="9007009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FD06B5BA-E490-4C15-B6B6-EEC74C950276}"/>
                </a:ext>
              </a:extLst>
            </p:cNvPr>
            <p:cNvSpPr txBox="1"/>
            <p:nvPr/>
          </p:nvSpPr>
          <p:spPr bwMode="auto">
            <a:xfrm>
              <a:off x="9594108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19" name="矩形 118">
              <a:extLst>
                <a:ext uri="{FF2B5EF4-FFF2-40B4-BE49-F238E27FC236}">
                  <a16:creationId xmlns:a16="http://schemas.microsoft.com/office/drawing/2014/main" id="{0CA92DAC-E097-4EC7-BB32-535B91D0E871}"/>
                </a:ext>
              </a:extLst>
            </p:cNvPr>
            <p:cNvSpPr/>
            <p:nvPr/>
          </p:nvSpPr>
          <p:spPr bwMode="auto">
            <a:xfrm>
              <a:off x="10176645" y="1006102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07B8CC95-A316-4A09-844D-5881D3A51739}"/>
                </a:ext>
              </a:extLst>
            </p:cNvPr>
            <p:cNvSpPr txBox="1"/>
            <p:nvPr/>
          </p:nvSpPr>
          <p:spPr bwMode="auto">
            <a:xfrm>
              <a:off x="8478051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21" name="矩形 120">
              <a:extLst>
                <a:ext uri="{FF2B5EF4-FFF2-40B4-BE49-F238E27FC236}">
                  <a16:creationId xmlns:a16="http://schemas.microsoft.com/office/drawing/2014/main" id="{BAD67841-02B8-43C9-B849-ECA055B94530}"/>
                </a:ext>
              </a:extLst>
            </p:cNvPr>
            <p:cNvSpPr/>
            <p:nvPr/>
          </p:nvSpPr>
          <p:spPr bwMode="auto">
            <a:xfrm>
              <a:off x="9594108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F59DF2E1-4B12-41D5-86C9-104E21290808}"/>
                </a:ext>
              </a:extLst>
            </p:cNvPr>
            <p:cNvSpPr txBox="1"/>
            <p:nvPr/>
          </p:nvSpPr>
          <p:spPr bwMode="auto">
            <a:xfrm>
              <a:off x="9007009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 algn="ctr">
                <a:defRPr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dirty="0">
                  <a:solidFill>
                    <a:srgbClr val="FF0000"/>
                  </a:solidFill>
                  <a:ea typeface="+mn-ea"/>
                </a:rPr>
                <a:t>−</a:t>
              </a:r>
              <a:endParaRPr lang="zh-CN" altLang="en-US" sz="1400" dirty="0">
                <a:solidFill>
                  <a:srgbClr val="FF0000"/>
                </a:solidFill>
                <a:ea typeface="+mn-ea"/>
              </a:endParaRPr>
            </a:p>
          </p:txBody>
        </p:sp>
        <p:sp>
          <p:nvSpPr>
            <p:cNvPr id="123" name="矩形 122">
              <a:extLst>
                <a:ext uri="{FF2B5EF4-FFF2-40B4-BE49-F238E27FC236}">
                  <a16:creationId xmlns:a16="http://schemas.microsoft.com/office/drawing/2014/main" id="{447A20F2-B199-48BC-B217-7AAE01FCB747}"/>
                </a:ext>
              </a:extLst>
            </p:cNvPr>
            <p:cNvSpPr/>
            <p:nvPr/>
          </p:nvSpPr>
          <p:spPr bwMode="auto">
            <a:xfrm>
              <a:off x="10176645" y="786391"/>
              <a:ext cx="104196" cy="215444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07E24BA7-67B3-4F5C-B988-0B79C57C777F}"/>
              </a:ext>
            </a:extLst>
          </p:cNvPr>
          <p:cNvGrpSpPr/>
          <p:nvPr/>
        </p:nvGrpSpPr>
        <p:grpSpPr>
          <a:xfrm>
            <a:off x="8686837" y="5241558"/>
            <a:ext cx="2849004" cy="449378"/>
            <a:chOff x="351367" y="1297742"/>
            <a:chExt cx="3342482" cy="449378"/>
          </a:xfrm>
        </p:grpSpPr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CB8C5552-807B-4426-A5BF-5B447338478E}"/>
                </a:ext>
              </a:extLst>
            </p:cNvPr>
            <p:cNvSpPr txBox="1"/>
            <p:nvPr/>
          </p:nvSpPr>
          <p:spPr>
            <a:xfrm>
              <a:off x="351367" y="1333181"/>
              <a:ext cx="2167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7D6040D1-7CF3-4AEE-882B-571E448D90F9}"/>
                </a:ext>
              </a:extLst>
            </p:cNvPr>
            <p:cNvSpPr/>
            <p:nvPr/>
          </p:nvSpPr>
          <p:spPr>
            <a:xfrm>
              <a:off x="1038153" y="1297742"/>
              <a:ext cx="2655696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28" name="文本框 127">
            <a:extLst>
              <a:ext uri="{FF2B5EF4-FFF2-40B4-BE49-F238E27FC236}">
                <a16:creationId xmlns:a16="http://schemas.microsoft.com/office/drawing/2014/main" id="{DFEC8735-EC79-40B9-84E5-FDE833E51688}"/>
              </a:ext>
            </a:extLst>
          </p:cNvPr>
          <p:cNvSpPr txBox="1"/>
          <p:nvPr/>
        </p:nvSpPr>
        <p:spPr>
          <a:xfrm>
            <a:off x="8367073" y="5271655"/>
            <a:ext cx="11067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6885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AF273D6-4444-41DE-BB40-679E385AFC0E}"/>
              </a:ext>
            </a:extLst>
          </p:cNvPr>
          <p:cNvSpPr txBox="1"/>
          <p:nvPr/>
        </p:nvSpPr>
        <p:spPr>
          <a:xfrm>
            <a:off x="180432" y="1758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6f </a:t>
            </a: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EA13B698-A157-4798-953A-66688E3CF5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771" y="1327858"/>
            <a:ext cx="3105172" cy="3750164"/>
          </a:xfrm>
          <a:prstGeom prst="rect">
            <a:avLst/>
          </a:prstGeom>
        </p:spPr>
      </p:pic>
      <p:grpSp>
        <p:nvGrpSpPr>
          <p:cNvPr id="56" name="组合 55">
            <a:extLst>
              <a:ext uri="{FF2B5EF4-FFF2-40B4-BE49-F238E27FC236}">
                <a16:creationId xmlns:a16="http://schemas.microsoft.com/office/drawing/2014/main" id="{18137B15-A212-48B9-AB59-8AD012424AB7}"/>
              </a:ext>
            </a:extLst>
          </p:cNvPr>
          <p:cNvGrpSpPr/>
          <p:nvPr/>
        </p:nvGrpSpPr>
        <p:grpSpPr>
          <a:xfrm>
            <a:off x="1159782" y="1563646"/>
            <a:ext cx="2781153" cy="462145"/>
            <a:chOff x="1314329" y="736598"/>
            <a:chExt cx="2781153" cy="462145"/>
          </a:xfrm>
        </p:grpSpPr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4128665D-C2F9-4F17-9DC3-E81E822ACA6E}"/>
                </a:ext>
              </a:extLst>
            </p:cNvPr>
            <p:cNvSpPr txBox="1"/>
            <p:nvPr/>
          </p:nvSpPr>
          <p:spPr bwMode="auto">
            <a:xfrm>
              <a:off x="1504552" y="983299"/>
              <a:ext cx="278923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9F5A66D-00C4-4F40-BA39-238853E4B552}"/>
                </a:ext>
              </a:extLst>
            </p:cNvPr>
            <p:cNvSpPr txBox="1"/>
            <p:nvPr/>
          </p:nvSpPr>
          <p:spPr bwMode="auto">
            <a:xfrm>
              <a:off x="2251791" y="983299"/>
              <a:ext cx="25968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OE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E27743FD-E260-4D79-8EE9-881E06E448A3}"/>
                </a:ext>
              </a:extLst>
            </p:cNvPr>
            <p:cNvCxnSpPr/>
            <p:nvPr/>
          </p:nvCxnSpPr>
          <p:spPr bwMode="auto">
            <a:xfrm flipV="1">
              <a:off x="1314329" y="987961"/>
              <a:ext cx="13136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F6026DB-4916-4B70-9C99-A3EA8BA2A101}"/>
                </a:ext>
              </a:extLst>
            </p:cNvPr>
            <p:cNvSpPr txBox="1"/>
            <p:nvPr/>
          </p:nvSpPr>
          <p:spPr bwMode="auto">
            <a:xfrm>
              <a:off x="1772843" y="736598"/>
              <a:ext cx="399147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ON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7BCDD20C-37C5-45D8-823B-F38B420493A4}"/>
                </a:ext>
              </a:extLst>
            </p:cNvPr>
            <p:cNvSpPr txBox="1"/>
            <p:nvPr/>
          </p:nvSpPr>
          <p:spPr bwMode="auto">
            <a:xfrm>
              <a:off x="2954067" y="743724"/>
              <a:ext cx="82554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9087633-4EC7-44DF-9056-92D4A685A15B}"/>
                </a:ext>
              </a:extLst>
            </p:cNvPr>
            <p:cNvSpPr txBox="1"/>
            <p:nvPr/>
          </p:nvSpPr>
          <p:spPr bwMode="auto">
            <a:xfrm>
              <a:off x="2931047" y="983299"/>
              <a:ext cx="278923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1312890-F8EF-4669-88F6-FB9F23186B9C}"/>
                </a:ext>
              </a:extLst>
            </p:cNvPr>
            <p:cNvSpPr txBox="1"/>
            <p:nvPr/>
          </p:nvSpPr>
          <p:spPr bwMode="auto">
            <a:xfrm>
              <a:off x="3662893" y="983299"/>
              <a:ext cx="25968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OE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1602812F-6E68-40B0-9A81-1C2A321E9C84}"/>
                </a:ext>
              </a:extLst>
            </p:cNvPr>
            <p:cNvCxnSpPr/>
            <p:nvPr/>
          </p:nvCxnSpPr>
          <p:spPr bwMode="auto">
            <a:xfrm flipV="1">
              <a:off x="2779310" y="997282"/>
              <a:ext cx="13161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8DF2557A-902E-416E-BDF6-57045833EF43}"/>
              </a:ext>
            </a:extLst>
          </p:cNvPr>
          <p:cNvGrpSpPr/>
          <p:nvPr/>
        </p:nvGrpSpPr>
        <p:grpSpPr>
          <a:xfrm>
            <a:off x="323258" y="2063905"/>
            <a:ext cx="3786575" cy="401414"/>
            <a:chOff x="323258" y="2063905"/>
            <a:chExt cx="3786575" cy="401414"/>
          </a:xfrm>
        </p:grpSpPr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B1033EF4-E424-41E7-AD90-B04B8C2BE8B9}"/>
                </a:ext>
              </a:extLst>
            </p:cNvPr>
            <p:cNvSpPr/>
            <p:nvPr/>
          </p:nvSpPr>
          <p:spPr bwMode="auto">
            <a:xfrm>
              <a:off x="323258" y="2120848"/>
              <a:ext cx="578685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FXN2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9E6D95D6-CB47-49B6-9672-A35C4D5DE506}"/>
                </a:ext>
              </a:extLst>
            </p:cNvPr>
            <p:cNvSpPr/>
            <p:nvPr/>
          </p:nvSpPr>
          <p:spPr>
            <a:xfrm>
              <a:off x="1084880" y="2063905"/>
              <a:ext cx="3024953" cy="401414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60" name="图片 59">
            <a:extLst>
              <a:ext uri="{FF2B5EF4-FFF2-40B4-BE49-F238E27FC236}">
                <a16:creationId xmlns:a16="http://schemas.microsoft.com/office/drawing/2014/main" id="{BE2BD5E1-C7C3-4D0A-B72C-4E8E199239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8474" y="1327858"/>
            <a:ext cx="3028258" cy="3750164"/>
          </a:xfrm>
          <a:prstGeom prst="rect">
            <a:avLst/>
          </a:prstGeom>
        </p:spPr>
      </p:pic>
      <p:grpSp>
        <p:nvGrpSpPr>
          <p:cNvPr id="62" name="组合 61">
            <a:extLst>
              <a:ext uri="{FF2B5EF4-FFF2-40B4-BE49-F238E27FC236}">
                <a16:creationId xmlns:a16="http://schemas.microsoft.com/office/drawing/2014/main" id="{AF63DEE1-B0CC-4662-948A-0A950F4D455D}"/>
              </a:ext>
            </a:extLst>
          </p:cNvPr>
          <p:cNvGrpSpPr/>
          <p:nvPr/>
        </p:nvGrpSpPr>
        <p:grpSpPr>
          <a:xfrm>
            <a:off x="5174071" y="2966855"/>
            <a:ext cx="2781153" cy="462145"/>
            <a:chOff x="1314329" y="736598"/>
            <a:chExt cx="2781153" cy="462145"/>
          </a:xfrm>
        </p:grpSpPr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BC5BC5DE-981E-4594-992D-1FDD9ED6A375}"/>
                </a:ext>
              </a:extLst>
            </p:cNvPr>
            <p:cNvSpPr txBox="1"/>
            <p:nvPr/>
          </p:nvSpPr>
          <p:spPr bwMode="auto">
            <a:xfrm>
              <a:off x="1504552" y="983299"/>
              <a:ext cx="278923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99492697-F3F2-450E-82DE-2A88DF0F712D}"/>
                </a:ext>
              </a:extLst>
            </p:cNvPr>
            <p:cNvSpPr txBox="1"/>
            <p:nvPr/>
          </p:nvSpPr>
          <p:spPr bwMode="auto">
            <a:xfrm>
              <a:off x="2251791" y="983299"/>
              <a:ext cx="25968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OE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8DBB0BB9-42EC-4035-AB9D-A4D470CBCEFF}"/>
                </a:ext>
              </a:extLst>
            </p:cNvPr>
            <p:cNvCxnSpPr/>
            <p:nvPr/>
          </p:nvCxnSpPr>
          <p:spPr bwMode="auto">
            <a:xfrm flipV="1">
              <a:off x="1314329" y="987961"/>
              <a:ext cx="13136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C3333C61-ED29-489B-BC53-2690ACDD92DB}"/>
                </a:ext>
              </a:extLst>
            </p:cNvPr>
            <p:cNvSpPr txBox="1"/>
            <p:nvPr/>
          </p:nvSpPr>
          <p:spPr bwMode="auto">
            <a:xfrm>
              <a:off x="1772843" y="736598"/>
              <a:ext cx="399147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ON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181B5172-6FF4-448C-9276-B99C0E7B6ED3}"/>
                </a:ext>
              </a:extLst>
            </p:cNvPr>
            <p:cNvSpPr txBox="1"/>
            <p:nvPr/>
          </p:nvSpPr>
          <p:spPr bwMode="auto">
            <a:xfrm>
              <a:off x="2954067" y="743724"/>
              <a:ext cx="82554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O-1-IN-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086B89E-5352-43ED-88E7-ABCEEC2FA253}"/>
                </a:ext>
              </a:extLst>
            </p:cNvPr>
            <p:cNvSpPr txBox="1"/>
            <p:nvPr/>
          </p:nvSpPr>
          <p:spPr bwMode="auto">
            <a:xfrm>
              <a:off x="2931047" y="983299"/>
              <a:ext cx="278923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9C97B5CF-6784-484C-A3C6-1109188863D6}"/>
                </a:ext>
              </a:extLst>
            </p:cNvPr>
            <p:cNvSpPr txBox="1"/>
            <p:nvPr/>
          </p:nvSpPr>
          <p:spPr bwMode="auto">
            <a:xfrm>
              <a:off x="3662893" y="983299"/>
              <a:ext cx="259686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ct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OE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FE910A10-D468-44C7-83E2-8170405CB11C}"/>
                </a:ext>
              </a:extLst>
            </p:cNvPr>
            <p:cNvCxnSpPr/>
            <p:nvPr/>
          </p:nvCxnSpPr>
          <p:spPr bwMode="auto">
            <a:xfrm flipV="1">
              <a:off x="2779310" y="997282"/>
              <a:ext cx="13161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B89F484A-0F3C-4556-8794-C20B47563899}"/>
              </a:ext>
            </a:extLst>
          </p:cNvPr>
          <p:cNvGrpSpPr/>
          <p:nvPr/>
        </p:nvGrpSpPr>
        <p:grpSpPr>
          <a:xfrm>
            <a:off x="4560150" y="3608587"/>
            <a:ext cx="3576582" cy="401414"/>
            <a:chOff x="533251" y="2063905"/>
            <a:chExt cx="3576582" cy="401414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9419E9A9-1BE4-4FFC-9189-3D173871ED21}"/>
                </a:ext>
              </a:extLst>
            </p:cNvPr>
            <p:cNvSpPr/>
            <p:nvPr/>
          </p:nvSpPr>
          <p:spPr bwMode="auto">
            <a:xfrm>
              <a:off x="533251" y="2120848"/>
              <a:ext cx="368692" cy="215444"/>
            </a:xfrm>
            <a:prstGeom prst="rect">
              <a:avLst/>
            </a:prstGeom>
            <a:noFill/>
          </p:spPr>
          <p:txBody>
            <a:bodyPr wrap="none" lIns="0" tIns="0" rIns="0" bIns="0">
              <a:spAutoFit/>
            </a:bodyPr>
            <a:lstStyle/>
            <a:p>
              <a:pPr algn="r" defTabSz="287552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1</a:t>
              </a:r>
              <a:endParaRPr lang="zh-CN" alt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528FAC0E-B0BE-4FA3-A93F-32B8AC925E29}"/>
                </a:ext>
              </a:extLst>
            </p:cNvPr>
            <p:cNvSpPr/>
            <p:nvPr/>
          </p:nvSpPr>
          <p:spPr>
            <a:xfrm>
              <a:off x="1084880" y="2063905"/>
              <a:ext cx="3024953" cy="401414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216F0B2E-8F99-4676-85D3-A359E62771D1}"/>
              </a:ext>
            </a:extLst>
          </p:cNvPr>
          <p:cNvGrpSpPr/>
          <p:nvPr/>
        </p:nvGrpSpPr>
        <p:grpSpPr>
          <a:xfrm>
            <a:off x="8326955" y="1824330"/>
            <a:ext cx="3776381" cy="2456992"/>
            <a:chOff x="8165683" y="2962691"/>
            <a:chExt cx="3776381" cy="2456992"/>
          </a:xfrm>
        </p:grpSpPr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F9E8988C-1CA0-4C59-AF63-14958B40BC5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8873252" y="2962691"/>
              <a:ext cx="3068812" cy="2456992"/>
            </a:xfrm>
            <a:prstGeom prst="rect">
              <a:avLst/>
            </a:prstGeom>
          </p:spPr>
        </p:pic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447C2CDF-EF80-458A-BEA1-A7A80A3F69C7}"/>
                </a:ext>
              </a:extLst>
            </p:cNvPr>
            <p:cNvGrpSpPr/>
            <p:nvPr/>
          </p:nvGrpSpPr>
          <p:grpSpPr>
            <a:xfrm>
              <a:off x="9034018" y="3454394"/>
              <a:ext cx="2781153" cy="462145"/>
              <a:chOff x="1314329" y="736598"/>
              <a:chExt cx="2781153" cy="462145"/>
            </a:xfrm>
          </p:grpSpPr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32992B6A-71B9-4710-BDDC-AB8E1DD23A84}"/>
                  </a:ext>
                </a:extLst>
              </p:cNvPr>
              <p:cNvSpPr txBox="1"/>
              <p:nvPr/>
            </p:nvSpPr>
            <p:spPr bwMode="auto">
              <a:xfrm>
                <a:off x="1504552" y="983299"/>
                <a:ext cx="278923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152501FA-F650-4411-8A59-975316E6DF47}"/>
                  </a:ext>
                </a:extLst>
              </p:cNvPr>
              <p:cNvSpPr txBox="1"/>
              <p:nvPr/>
            </p:nvSpPr>
            <p:spPr bwMode="auto">
              <a:xfrm>
                <a:off x="2251791" y="983299"/>
                <a:ext cx="259686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OE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81" name="直接连接符 80">
                <a:extLst>
                  <a:ext uri="{FF2B5EF4-FFF2-40B4-BE49-F238E27FC236}">
                    <a16:creationId xmlns:a16="http://schemas.microsoft.com/office/drawing/2014/main" id="{B8DC6B32-F319-4EC9-B65E-8BABA44AC03B}"/>
                  </a:ext>
                </a:extLst>
              </p:cNvPr>
              <p:cNvCxnSpPr/>
              <p:nvPr/>
            </p:nvCxnSpPr>
            <p:spPr bwMode="auto">
              <a:xfrm flipV="1">
                <a:off x="1314329" y="987961"/>
                <a:ext cx="13136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71A50156-0900-49DE-844C-6154590D99FA}"/>
                  </a:ext>
                </a:extLst>
              </p:cNvPr>
              <p:cNvSpPr txBox="1"/>
              <p:nvPr/>
            </p:nvSpPr>
            <p:spPr bwMode="auto">
              <a:xfrm>
                <a:off x="1772843" y="736598"/>
                <a:ext cx="399147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391E4FD8-0798-44FD-802D-B5634C6B01DC}"/>
                  </a:ext>
                </a:extLst>
              </p:cNvPr>
              <p:cNvSpPr txBox="1"/>
              <p:nvPr/>
            </p:nvSpPr>
            <p:spPr bwMode="auto">
              <a:xfrm>
                <a:off x="2954067" y="743724"/>
                <a:ext cx="825546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O-1-IN-1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D792EF59-F1B6-4558-855E-EF8CFEF996B2}"/>
                  </a:ext>
                </a:extLst>
              </p:cNvPr>
              <p:cNvSpPr txBox="1"/>
              <p:nvPr/>
            </p:nvSpPr>
            <p:spPr bwMode="auto">
              <a:xfrm>
                <a:off x="2931047" y="983299"/>
                <a:ext cx="278923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66CB1459-9831-4C21-AADF-F2FF7557364A}"/>
                  </a:ext>
                </a:extLst>
              </p:cNvPr>
              <p:cNvSpPr txBox="1"/>
              <p:nvPr/>
            </p:nvSpPr>
            <p:spPr bwMode="auto">
              <a:xfrm>
                <a:off x="3662893" y="983299"/>
                <a:ext cx="259686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ctr" defTabSz="287552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OE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6C3EC500-FFAC-482E-BDC6-6E58B7130CBD}"/>
                  </a:ext>
                </a:extLst>
              </p:cNvPr>
              <p:cNvCxnSpPr/>
              <p:nvPr/>
            </p:nvCxnSpPr>
            <p:spPr bwMode="auto">
              <a:xfrm flipV="1">
                <a:off x="2779310" y="997282"/>
                <a:ext cx="131617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6FFE34F8-1761-4FD9-A860-A5CEB0E8B9F3}"/>
                </a:ext>
              </a:extLst>
            </p:cNvPr>
            <p:cNvGrpSpPr/>
            <p:nvPr/>
          </p:nvGrpSpPr>
          <p:grpSpPr>
            <a:xfrm>
              <a:off x="8165683" y="3983912"/>
              <a:ext cx="3727263" cy="401414"/>
              <a:chOff x="382570" y="2063905"/>
              <a:chExt cx="3727263" cy="401414"/>
            </a:xfrm>
          </p:grpSpPr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33001FD7-F0C0-4340-B7E6-6F24A11675F8}"/>
                  </a:ext>
                </a:extLst>
              </p:cNvPr>
              <p:cNvSpPr/>
              <p:nvPr/>
            </p:nvSpPr>
            <p:spPr bwMode="auto">
              <a:xfrm>
                <a:off x="382570" y="2120848"/>
                <a:ext cx="585096" cy="215444"/>
              </a:xfrm>
              <a:prstGeom prst="rect">
                <a:avLst/>
              </a:prstGeom>
              <a:noFill/>
            </p:spPr>
            <p:txBody>
              <a:bodyPr wrap="none" lIns="0" tIns="0" rIns="0" bIns="0">
                <a:spAutoFit/>
              </a:bodyPr>
              <a:lstStyle/>
              <a:p>
                <a:pPr algn="r" defTabSz="287552">
                  <a:defRPr/>
                </a:pPr>
                <a:r>
                  <a:rPr lang="en-US" altLang="zh-CN" sz="14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44B79F5B-D21E-4048-9D1F-0C25D864B58D}"/>
                  </a:ext>
                </a:extLst>
              </p:cNvPr>
              <p:cNvSpPr/>
              <p:nvPr/>
            </p:nvSpPr>
            <p:spPr>
              <a:xfrm>
                <a:off x="1084880" y="2063905"/>
                <a:ext cx="3024953" cy="401414"/>
              </a:xfrm>
              <a:prstGeom prst="rect">
                <a:avLst/>
              </a:pr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741076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DE114B42-1749-4C04-ADCC-8A28D2405275}"/>
              </a:ext>
            </a:extLst>
          </p:cNvPr>
          <p:cNvSpPr txBox="1"/>
          <p:nvPr/>
        </p:nvSpPr>
        <p:spPr>
          <a:xfrm>
            <a:off x="180432" y="17588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6g </a:t>
            </a: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3E0CC15C-9B5A-4622-AD8D-3EB84C1B2A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663" y="1480722"/>
            <a:ext cx="3308135" cy="392455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C9B2BF65-4E6E-4795-B1B2-2494381B77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900" y="2819805"/>
            <a:ext cx="1401098" cy="896902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6621C5F-8D4F-4900-99D7-23CD52B840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2907" y="2816087"/>
            <a:ext cx="1390564" cy="896902"/>
          </a:xfrm>
          <a:prstGeom prst="rect">
            <a:avLst/>
          </a:prstGeom>
        </p:spPr>
      </p:pic>
      <p:grpSp>
        <p:nvGrpSpPr>
          <p:cNvPr id="29" name="组合 28">
            <a:extLst>
              <a:ext uri="{FF2B5EF4-FFF2-40B4-BE49-F238E27FC236}">
                <a16:creationId xmlns:a16="http://schemas.microsoft.com/office/drawing/2014/main" id="{043D660C-21E6-4A2A-9C79-4BD7520D6EE8}"/>
              </a:ext>
            </a:extLst>
          </p:cNvPr>
          <p:cNvGrpSpPr/>
          <p:nvPr/>
        </p:nvGrpSpPr>
        <p:grpSpPr>
          <a:xfrm>
            <a:off x="337123" y="3659821"/>
            <a:ext cx="4498893" cy="449378"/>
            <a:chOff x="337123" y="3659821"/>
            <a:chExt cx="4498893" cy="449378"/>
          </a:xfrm>
        </p:grpSpPr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0ADC2E45-9477-4B6E-A8FD-50FC618B0115}"/>
                </a:ext>
              </a:extLst>
            </p:cNvPr>
            <p:cNvSpPr/>
            <p:nvPr/>
          </p:nvSpPr>
          <p:spPr>
            <a:xfrm>
              <a:off x="1395663" y="3659821"/>
              <a:ext cx="3440353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E287979-DBE9-4F1B-81CF-0F4FCD758BD9}"/>
                </a:ext>
              </a:extLst>
            </p:cNvPr>
            <p:cNvSpPr txBox="1"/>
            <p:nvPr/>
          </p:nvSpPr>
          <p:spPr>
            <a:xfrm>
              <a:off x="337123" y="3659821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FXN2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9A3AC99B-DBAB-4F11-BCBD-3EAAC19EDC71}"/>
              </a:ext>
            </a:extLst>
          </p:cNvPr>
          <p:cNvGrpSpPr/>
          <p:nvPr/>
        </p:nvGrpSpPr>
        <p:grpSpPr>
          <a:xfrm>
            <a:off x="337123" y="4136341"/>
            <a:ext cx="4498893" cy="449378"/>
            <a:chOff x="337123" y="3659821"/>
            <a:chExt cx="4498893" cy="449378"/>
          </a:xfrm>
        </p:grpSpPr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C8CA549B-3273-4742-AFE2-4BA199CF7529}"/>
                </a:ext>
              </a:extLst>
            </p:cNvPr>
            <p:cNvSpPr/>
            <p:nvPr/>
          </p:nvSpPr>
          <p:spPr>
            <a:xfrm>
              <a:off x="1395663" y="3659821"/>
              <a:ext cx="3440353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7CCD35B-940D-40D3-902F-D2D48BEA5B22}"/>
                </a:ext>
              </a:extLst>
            </p:cNvPr>
            <p:cNvSpPr txBox="1"/>
            <p:nvPr/>
          </p:nvSpPr>
          <p:spPr>
            <a:xfrm>
              <a:off x="337123" y="3659821"/>
              <a:ext cx="6591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1</a:t>
              </a:r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4" name="图片 33">
            <a:extLst>
              <a:ext uri="{FF2B5EF4-FFF2-40B4-BE49-F238E27FC236}">
                <a16:creationId xmlns:a16="http://schemas.microsoft.com/office/drawing/2014/main" id="{50DA779B-0D80-45BE-964F-4B5F36BEFD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290330"/>
            <a:ext cx="3766874" cy="4277339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4263ED29-C08B-497D-9CC4-31CA5F78EA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0715" y="3239439"/>
            <a:ext cx="1401098" cy="896902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3356F593-D9E9-4F76-88D6-B4ECB8C9AD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8722" y="3235721"/>
            <a:ext cx="1390564" cy="896902"/>
          </a:xfrm>
          <a:prstGeom prst="rect">
            <a:avLst/>
          </a:prstGeom>
        </p:spPr>
      </p:pic>
      <p:grpSp>
        <p:nvGrpSpPr>
          <p:cNvPr id="37" name="组合 36">
            <a:extLst>
              <a:ext uri="{FF2B5EF4-FFF2-40B4-BE49-F238E27FC236}">
                <a16:creationId xmlns:a16="http://schemas.microsoft.com/office/drawing/2014/main" id="{8EE22BE7-A4FB-4A8B-A8EE-5E70376AD517}"/>
              </a:ext>
            </a:extLst>
          </p:cNvPr>
          <p:cNvGrpSpPr/>
          <p:nvPr/>
        </p:nvGrpSpPr>
        <p:grpSpPr>
          <a:xfrm>
            <a:off x="5189256" y="4151316"/>
            <a:ext cx="4416176" cy="646331"/>
            <a:chOff x="419840" y="3659821"/>
            <a:chExt cx="4416176" cy="646331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EDC63024-B4A6-4707-9492-6C9AD1F5806A}"/>
                </a:ext>
              </a:extLst>
            </p:cNvPr>
            <p:cNvSpPr/>
            <p:nvPr/>
          </p:nvSpPr>
          <p:spPr>
            <a:xfrm>
              <a:off x="1395663" y="3659821"/>
              <a:ext cx="3440353" cy="44937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E702358C-F352-4ED4-A461-B8207ECDB7EF}"/>
                </a:ext>
              </a:extLst>
            </p:cNvPr>
            <p:cNvSpPr txBox="1"/>
            <p:nvPr/>
          </p:nvSpPr>
          <p:spPr>
            <a:xfrm>
              <a:off x="419840" y="3659821"/>
              <a:ext cx="94128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n-US" altLang="zh-CN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  <a:p>
              <a:endParaRPr lang="zh-CN" alt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66960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6</TotalTime>
  <Words>257</Words>
  <Application>Microsoft Office PowerPoint</Application>
  <PresentationFormat>宽屏</PresentationFormat>
  <Paragraphs>21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ing Pinggang</dc:creator>
  <cp:lastModifiedBy>Ding Pinggang</cp:lastModifiedBy>
  <cp:revision>12</cp:revision>
  <dcterms:created xsi:type="dcterms:W3CDTF">2022-04-03T04:33:19Z</dcterms:created>
  <dcterms:modified xsi:type="dcterms:W3CDTF">2022-07-07T00:31:34Z</dcterms:modified>
</cp:coreProperties>
</file>